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64.xml.rels" ContentType="application/vnd.openxmlformats-package.relationships+xml"/>
  <Override PartName="/ppt/notesSlides/_rels/notesSlide37.xml.rels" ContentType="application/vnd.openxmlformats-package.relationships+xml"/>
  <Override PartName="/ppt/notesSlides/notesSlide37.xml" ContentType="application/vnd.openxmlformats-officedocument.presentationml.notesSlide+xml"/>
  <Override PartName="/ppt/notesSlides/notesSlide64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png" ContentType="image/pn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media/image7.jpeg" ContentType="image/jpeg"/>
  <Override PartName="/ppt/media/image8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56.xml" ContentType="application/vnd.openxmlformats-officedocument.presentationml.slide+xml"/>
  <Override PartName="/ppt/slides/slide55.xml" ContentType="application/vnd.openxmlformats-officedocument.presentationml.slide+xml"/>
  <Override PartName="/ppt/slides/slide54.xml" ContentType="application/vnd.openxmlformats-officedocument.presentationml.slide+xml"/>
  <Override PartName="/ppt/slides/slide53.xml" ContentType="application/vnd.openxmlformats-officedocument.presentationml.slide+xml"/>
  <Override PartName="/ppt/slides/slide52.xml" ContentType="application/vnd.openxmlformats-officedocument.presentationml.slide+xml"/>
  <Override PartName="/ppt/slides/slide51.xml" ContentType="application/vnd.openxmlformats-officedocument.presentationml.slide+xml"/>
  <Override PartName="/ppt/slides/slide50.xml" ContentType="application/vnd.openxmlformats-officedocument.presentationml.slide+xml"/>
  <Override PartName="/ppt/slides/slide42.xml" ContentType="application/vnd.openxmlformats-officedocument.presentationml.slide+xml"/>
  <Override PartName="/ppt/slides/slide7.xml" ContentType="application/vnd.openxmlformats-officedocument.presentationml.slide+xml"/>
  <Override PartName="/ppt/slides/slide14.xml" ContentType="application/vnd.openxmlformats-officedocument.presentationml.slide+xml"/>
  <Override PartName="/ppt/slides/slide41.xml" ContentType="application/vnd.openxmlformats-officedocument.presentationml.slide+xml"/>
  <Override PartName="/ppt/slides/slide40.xml" ContentType="application/vnd.openxmlformats-officedocument.presentationml.slide+xml"/>
  <Override PartName="/ppt/slides/slide2.xml" ContentType="application/vnd.openxmlformats-officedocument.presentationml.slide+xml"/>
  <Override PartName="/ppt/slides/slide1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60.xml" ContentType="application/vnd.openxmlformats-officedocument.presentationml.slide+xml"/>
  <Override PartName="/ppt/slides/slide20.xml" ContentType="application/vnd.openxmlformats-officedocument.presentationml.slide+xml"/>
  <Override PartName="/ppt/slides/slide57.xml" ContentType="application/vnd.openxmlformats-officedocument.presentationml.slide+xml"/>
  <Override PartName="/ppt/slides/slide19.xml" ContentType="application/vnd.openxmlformats-officedocument.presentationml.slide+xml"/>
  <Override PartName="/ppt/slides/slide61.xml" ContentType="application/vnd.openxmlformats-officedocument.presentationml.slide+xml"/>
  <Override PartName="/ppt/slides/slide21.xml" ContentType="application/vnd.openxmlformats-officedocument.presentationml.slide+xml"/>
  <Override PartName="/ppt/slides/slide58.xml" ContentType="application/vnd.openxmlformats-officedocument.presentationml.slide+xml"/>
  <Override PartName="/ppt/slides/slide22.xml" ContentType="application/vnd.openxmlformats-officedocument.presentationml.slide+xml"/>
  <Override PartName="/ppt/slides/slide59.xml" ContentType="application/vnd.openxmlformats-officedocument.presentationml.slide+xml"/>
  <Override PartName="/ppt/slides/slide66.xml" ContentType="application/vnd.openxmlformats-officedocument.presentationml.slide+xml"/>
  <Override PartName="/ppt/slides/slide29.xml" ContentType="application/vnd.openxmlformats-officedocument.presentationml.slide+xml"/>
  <Override PartName="/ppt/slides/slide65.xml" ContentType="application/vnd.openxmlformats-officedocument.presentationml.slide+xml"/>
  <Override PartName="/ppt/slides/slide28.xml" ContentType="application/vnd.openxmlformats-officedocument.presentationml.slide+xml"/>
  <Override PartName="/ppt/slides/slide64.xml" ContentType="application/vnd.openxmlformats-officedocument.presentationml.slide+xml"/>
  <Override PartName="/ppt/slides/slide27.xml" ContentType="application/vnd.openxmlformats-officedocument.presentationml.slide+xml"/>
  <Override PartName="/ppt/slides/slide63.xml" ContentType="application/vnd.openxmlformats-officedocument.presentationml.slide+xml"/>
  <Override PartName="/ppt/slides/slide26.xml" ContentType="application/vnd.openxmlformats-officedocument.presentationml.slide+xml"/>
  <Override PartName="/ppt/slides/slide23.xml" ContentType="application/vnd.openxmlformats-officedocument.presentationml.slide+xml"/>
  <Override PartName="/ppt/slides/slide62.xml" ContentType="application/vnd.openxmlformats-officedocument.presentationml.slide+xml"/>
  <Override PartName="/ppt/slides/slide25.xml" ContentType="application/vnd.openxmlformats-officedocument.presentationml.slide+xml"/>
  <Override PartName="/ppt/slides/slide24.xml" ContentType="application/vnd.openxmlformats-officedocument.presentationml.slide+xml"/>
  <Override PartName="/ppt/slides/slide3.xml" ContentType="application/vnd.openxmlformats-officedocument.presentationml.slide+xml"/>
  <Override PartName="/ppt/slides/slide10.xml" ContentType="application/vnd.openxmlformats-officedocument.presentationml.slide+xml"/>
  <Override PartName="/ppt/slides/slide47.xml" ContentType="application/vnd.openxmlformats-officedocument.presentationml.slide+xml"/>
  <Override PartName="/ppt/slides/slide15.xml" ContentType="application/vnd.openxmlformats-officedocument.presentationml.slide+xml"/>
  <Override PartName="/ppt/slides/slide8.xml" ContentType="application/vnd.openxmlformats-officedocument.presentationml.slide+xml"/>
  <Override PartName="/ppt/slides/slide43.xml" ContentType="application/vnd.openxmlformats-officedocument.presentationml.slide+xml"/>
  <Override PartName="/ppt/slides/slide4.xml" ContentType="application/vnd.openxmlformats-officedocument.presentationml.slide+xml"/>
  <Override PartName="/ppt/slides/slide11.xml" ContentType="application/vnd.openxmlformats-officedocument.presentationml.slide+xml"/>
  <Override PartName="/ppt/slides/slide48.xml" ContentType="application/vnd.openxmlformats-officedocument.presentationml.slide+xml"/>
  <Override PartName="/ppt/slides/slide16.xml" ContentType="application/vnd.openxmlformats-officedocument.presentationml.slide+xml"/>
  <Override PartName="/ppt/slides/slide9.xml" ContentType="application/vnd.openxmlformats-officedocument.presentationml.slide+xml"/>
  <Override PartName="/ppt/slides/slide44.xml" ContentType="application/vnd.openxmlformats-officedocument.presentationml.slide+xml"/>
  <Override PartName="/ppt/slides/slide5.xml" ContentType="application/vnd.openxmlformats-officedocument.presentationml.slide+xml"/>
  <Override PartName="/ppt/slides/slide12.xml" ContentType="application/vnd.openxmlformats-officedocument.presentationml.slide+xml"/>
  <Override PartName="/ppt/slides/slide49.xml" ContentType="application/vnd.openxmlformats-officedocument.presentationml.slide+xml"/>
  <Override PartName="/ppt/slides/_rels/slide39.xml.rels" ContentType="application/vnd.openxmlformats-package.relationships+xml"/>
  <Override PartName="/ppt/slides/_rels/slide31.xml.rels" ContentType="application/vnd.openxmlformats-package.relationships+xml"/>
  <Override PartName="/ppt/slides/_rels/slide15.xml.rels" ContentType="application/vnd.openxmlformats-package.relationships+xml"/>
  <Override PartName="/ppt/slides/_rels/slide24.xml.rels" ContentType="application/vnd.openxmlformats-package.relationships+xml"/>
  <Override PartName="/ppt/slides/_rels/slide32.xml.rels" ContentType="application/vnd.openxmlformats-package.relationships+xml"/>
  <Override PartName="/ppt/slides/_rels/slide1.xml.rels" ContentType="application/vnd.openxmlformats-package.relationships+xml"/>
  <Override PartName="/ppt/slides/_rels/slide58.xml.rels" ContentType="application/vnd.openxmlformats-package.relationships+xml"/>
  <Override PartName="/ppt/slides/_rels/slide65.xml.rels" ContentType="application/vnd.openxmlformats-package.relationships+xml"/>
  <Override PartName="/ppt/slides/_rels/slide13.xml.rels" ContentType="application/vnd.openxmlformats-package.relationships+xml"/>
  <Override PartName="/ppt/slides/_rels/slide27.xml.rels" ContentType="application/vnd.openxmlformats-package.relationships+xml"/>
  <Override PartName="/ppt/slides/_rels/slide36.xml.rels" ContentType="application/vnd.openxmlformats-package.relationships+xml"/>
  <Override PartName="/ppt/slides/_rels/slide43.xml.rels" ContentType="application/vnd.openxmlformats-package.relationships+xml"/>
  <Override PartName="/ppt/slides/_rels/slide8.xml.rels" ContentType="application/vnd.openxmlformats-package.relationships+xml"/>
  <Override PartName="/ppt/slides/_rels/slide2.xml.rels" ContentType="application/vnd.openxmlformats-package.relationships+xml"/>
  <Override PartName="/ppt/slides/_rels/slide21.xml.rels" ContentType="application/vnd.openxmlformats-package.relationships+xml"/>
  <Override PartName="/ppt/slides/_rels/slide17.xml.rels" ContentType="application/vnd.openxmlformats-package.relationships+xml"/>
  <Override PartName="/ppt/slides/_rels/slide11.xml.rels" ContentType="application/vnd.openxmlformats-package.relationships+xml"/>
  <Override PartName="/ppt/slides/_rels/slide26.xml.rels" ContentType="application/vnd.openxmlformats-package.relationships+xml"/>
  <Override PartName="/ppt/slides/_rels/slide12.xml.rels" ContentType="application/vnd.openxmlformats-package.relationships+xml"/>
  <Override PartName="/ppt/slides/_rels/slide48.xml.rels" ContentType="application/vnd.openxmlformats-package.relationships+xml"/>
  <Override PartName="/ppt/slides/_rels/slide64.xml.rels" ContentType="application/vnd.openxmlformats-package.relationships+xml"/>
  <Override PartName="/ppt/slides/_rels/slide5.xml.rels" ContentType="application/vnd.openxmlformats-package.relationships+xml"/>
  <Override PartName="/ppt/slides/_rels/slide40.xml.rels" ContentType="application/vnd.openxmlformats-package.relationships+xml"/>
  <Override PartName="/ppt/slides/_rels/slide55.xml.rels" ContentType="application/vnd.openxmlformats-package.relationships+xml"/>
  <Override PartName="/ppt/slides/_rels/slide35.xml.rels" ContentType="application/vnd.openxmlformats-package.relationships+xml"/>
  <Override PartName="/ppt/slides/_rels/slide51.xml.rels" ContentType="application/vnd.openxmlformats-package.relationships+xml"/>
  <Override PartName="/ppt/slides/_rels/slide42.xml.rels" ContentType="application/vnd.openxmlformats-package.relationships+xml"/>
  <Override PartName="/ppt/slides/_rels/slide7.xml.rels" ContentType="application/vnd.openxmlformats-package.relationships+xml"/>
  <Override PartName="/ppt/slides/_rels/slide16.xml.rels" ContentType="application/vnd.openxmlformats-package.relationships+xml"/>
  <Override PartName="/ppt/slides/_rels/slide20.xml.rels" ContentType="application/vnd.openxmlformats-package.relationships+xml"/>
  <Override PartName="/ppt/slides/_rels/slide54.xml.rels" ContentType="application/vnd.openxmlformats-package.relationships+xml"/>
  <Override PartName="/ppt/slides/_rels/slide63.xml.rels" ContentType="application/vnd.openxmlformats-package.relationships+xml"/>
  <Override PartName="/ppt/slides/_rels/slide47.xml.rels" ContentType="application/vnd.openxmlformats-package.relationships+xml"/>
  <Override PartName="/ppt/slides/_rels/slide4.xml.rels" ContentType="application/vnd.openxmlformats-package.relationships+xml"/>
  <Override PartName="/ppt/slides/_rels/slide41.xml.rels" ContentType="application/vnd.openxmlformats-package.relationships+xml"/>
  <Override PartName="/ppt/slides/_rels/slide6.xml.rels" ContentType="application/vnd.openxmlformats-package.relationships+xml"/>
  <Override PartName="/ppt/slides/_rels/slide34.xml.rels" ContentType="application/vnd.openxmlformats-package.relationships+xml"/>
  <Override PartName="/ppt/slides/_rels/slide50.xml.rels" ContentType="application/vnd.openxmlformats-package.relationships+xml"/>
  <Override PartName="/ppt/slides/_rels/slide49.xml.rels" ContentType="application/vnd.openxmlformats-package.relationships+xml"/>
  <Override PartName="/ppt/slides/_rels/slide53.xml.rels" ContentType="application/vnd.openxmlformats-package.relationships+xml"/>
  <Override PartName="/ppt/slides/_rels/slide62.xml.rels" ContentType="application/vnd.openxmlformats-package.relationships+xml"/>
  <Override PartName="/ppt/slides/_rels/slide46.xml.rels" ContentType="application/vnd.openxmlformats-package.relationships+xml"/>
  <Override PartName="/ppt/slides/_rels/slide52.xml.rels" ContentType="application/vnd.openxmlformats-package.relationships+xml"/>
  <Override PartName="/ppt/slides/_rels/slide57.xml.rels" ContentType="application/vnd.openxmlformats-package.relationships+xml"/>
  <Override PartName="/ppt/slides/_rels/slide61.xml.rels" ContentType="application/vnd.openxmlformats-package.relationships+xml"/>
  <Override PartName="/ppt/slides/_rels/slide18.xml.rels" ContentType="application/vnd.openxmlformats-package.relationships+xml"/>
  <Override PartName="/ppt/slides/_rels/slide22.xml.rels" ContentType="application/vnd.openxmlformats-package.relationships+xml"/>
  <Override PartName="/ppt/slides/_rels/slide28.xml.rels" ContentType="application/vnd.openxmlformats-package.relationships+xml"/>
  <Override PartName="/ppt/slides/_rels/slide3.xml.rels" ContentType="application/vnd.openxmlformats-package.relationships+xml"/>
  <Override PartName="/ppt/slides/_rels/slide9.xml.rels" ContentType="application/vnd.openxmlformats-package.relationships+xml"/>
  <Override PartName="/ppt/slides/_rels/slide44.xml.rels" ContentType="application/vnd.openxmlformats-package.relationships+xml"/>
  <Override PartName="/ppt/slides/_rels/slide37.xml.rels" ContentType="application/vnd.openxmlformats-package.relationships+xml"/>
  <Override PartName="/ppt/slides/_rels/slide19.xml.rels" ContentType="application/vnd.openxmlformats-package.relationships+xml"/>
  <Override PartName="/ppt/slides/_rels/slide23.xml.rels" ContentType="application/vnd.openxmlformats-package.relationships+xml"/>
  <Override PartName="/ppt/slides/_rels/slide14.xml.rels" ContentType="application/vnd.openxmlformats-package.relationships+xml"/>
  <Override PartName="/ppt/slides/_rels/slide33.xml.rels" ContentType="application/vnd.openxmlformats-package.relationships+xml"/>
  <Override PartName="/ppt/slides/_rels/slide29.xml.rels" ContentType="application/vnd.openxmlformats-package.relationships+xml"/>
  <Override PartName="/ppt/slides/_rels/slide30.xml.rels" ContentType="application/vnd.openxmlformats-package.relationships+xml"/>
  <Override PartName="/ppt/slides/_rels/slide38.xml.rels" ContentType="application/vnd.openxmlformats-package.relationships+xml"/>
  <Override PartName="/ppt/slides/_rels/slide45.xml.rels" ContentType="application/vnd.openxmlformats-package.relationships+xml"/>
  <Override PartName="/ppt/slides/_rels/slide66.xml.rels" ContentType="application/vnd.openxmlformats-package.relationships+xml"/>
  <Override PartName="/ppt/slides/_rels/slide56.xml.rels" ContentType="application/vnd.openxmlformats-package.relationships+xml"/>
  <Override PartName="/ppt/slides/_rels/slide60.xml.rels" ContentType="application/vnd.openxmlformats-package.relationships+xml"/>
  <Override PartName="/ppt/slides/_rels/slide25.xml.rels" ContentType="application/vnd.openxmlformats-package.relationships+xml"/>
  <Override PartName="/ppt/slides/_rels/slide59.xml.rels" ContentType="application/vnd.openxmlformats-package.relationships+xml"/>
  <Override PartName="/ppt/slides/_rels/slide10.xml.rels" ContentType="application/vnd.openxmlformats-package.relationships+xml"/>
  <Override PartName="/ppt/slides/slide6.xml" ContentType="application/vnd.openxmlformats-officedocument.presentationml.slide+xml"/>
  <Override PartName="/ppt/slides/slide13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  <p:sldId id="269" r:id="rId17"/>
    <p:sldId id="270" r:id="rId18"/>
    <p:sldId id="271" r:id="rId19"/>
    <p:sldId id="272" r:id="rId20"/>
    <p:sldId id="273" r:id="rId21"/>
    <p:sldId id="274" r:id="rId22"/>
    <p:sldId id="275" r:id="rId23"/>
    <p:sldId id="276" r:id="rId24"/>
    <p:sldId id="277" r:id="rId25"/>
    <p:sldId id="278" r:id="rId26"/>
    <p:sldId id="279" r:id="rId27"/>
    <p:sldId id="280" r:id="rId28"/>
    <p:sldId id="281" r:id="rId29"/>
    <p:sldId id="282" r:id="rId30"/>
    <p:sldId id="283" r:id="rId31"/>
    <p:sldId id="284" r:id="rId32"/>
    <p:sldId id="285" r:id="rId33"/>
    <p:sldId id="286" r:id="rId34"/>
    <p:sldId id="287" r:id="rId35"/>
    <p:sldId id="288" r:id="rId36"/>
    <p:sldId id="289" r:id="rId37"/>
    <p:sldId id="290" r:id="rId38"/>
    <p:sldId id="291" r:id="rId39"/>
    <p:sldId id="292" r:id="rId40"/>
    <p:sldId id="293" r:id="rId41"/>
    <p:sldId id="294" r:id="rId42"/>
    <p:sldId id="295" r:id="rId43"/>
    <p:sldId id="296" r:id="rId44"/>
    <p:sldId id="297" r:id="rId45"/>
    <p:sldId id="298" r:id="rId46"/>
    <p:sldId id="299" r:id="rId47"/>
    <p:sldId id="300" r:id="rId48"/>
    <p:sldId id="301" r:id="rId49"/>
    <p:sldId id="302" r:id="rId50"/>
    <p:sldId id="303" r:id="rId51"/>
    <p:sldId id="304" r:id="rId52"/>
    <p:sldId id="305" r:id="rId53"/>
    <p:sldId id="306" r:id="rId54"/>
    <p:sldId id="307" r:id="rId55"/>
    <p:sldId id="308" r:id="rId56"/>
    <p:sldId id="309" r:id="rId57"/>
    <p:sldId id="310" r:id="rId58"/>
    <p:sldId id="311" r:id="rId59"/>
    <p:sldId id="312" r:id="rId60"/>
    <p:sldId id="313" r:id="rId61"/>
    <p:sldId id="314" r:id="rId62"/>
    <p:sldId id="315" r:id="rId63"/>
    <p:sldId id="316" r:id="rId64"/>
    <p:sldId id="317" r:id="rId65"/>
    <p:sldId id="318" r:id="rId66"/>
    <p:sldId id="319" r:id="rId67"/>
    <p:sldId id="320" r:id="rId68"/>
    <p:sldId id="321" r:id="rId69"/>
  </p:sldIdLst>
  <p:sldSz cx="10288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slide" Target="slides/slide13.xml"/><Relationship Id="rId17" Type="http://schemas.openxmlformats.org/officeDocument/2006/relationships/slide" Target="slides/slide14.xml"/><Relationship Id="rId18" Type="http://schemas.openxmlformats.org/officeDocument/2006/relationships/slide" Target="slides/slide15.xml"/><Relationship Id="rId19" Type="http://schemas.openxmlformats.org/officeDocument/2006/relationships/slide" Target="slides/slide16.xml"/><Relationship Id="rId20" Type="http://schemas.openxmlformats.org/officeDocument/2006/relationships/slide" Target="slides/slide17.xml"/><Relationship Id="rId21" Type="http://schemas.openxmlformats.org/officeDocument/2006/relationships/slide" Target="slides/slide18.xml"/><Relationship Id="rId22" Type="http://schemas.openxmlformats.org/officeDocument/2006/relationships/slide" Target="slides/slide19.xml"/><Relationship Id="rId23" Type="http://schemas.openxmlformats.org/officeDocument/2006/relationships/slide" Target="slides/slide20.xml"/><Relationship Id="rId24" Type="http://schemas.openxmlformats.org/officeDocument/2006/relationships/slide" Target="slides/slide21.xml"/><Relationship Id="rId25" Type="http://schemas.openxmlformats.org/officeDocument/2006/relationships/slide" Target="slides/slide22.xml"/><Relationship Id="rId26" Type="http://schemas.openxmlformats.org/officeDocument/2006/relationships/slide" Target="slides/slide23.xml"/><Relationship Id="rId27" Type="http://schemas.openxmlformats.org/officeDocument/2006/relationships/slide" Target="slides/slide24.xml"/><Relationship Id="rId28" Type="http://schemas.openxmlformats.org/officeDocument/2006/relationships/slide" Target="slides/slide25.xml"/><Relationship Id="rId29" Type="http://schemas.openxmlformats.org/officeDocument/2006/relationships/slide" Target="slides/slide26.xml"/><Relationship Id="rId30" Type="http://schemas.openxmlformats.org/officeDocument/2006/relationships/slide" Target="slides/slide27.xml"/><Relationship Id="rId31" Type="http://schemas.openxmlformats.org/officeDocument/2006/relationships/slide" Target="slides/slide28.xml"/><Relationship Id="rId32" Type="http://schemas.openxmlformats.org/officeDocument/2006/relationships/slide" Target="slides/slide29.xml"/><Relationship Id="rId33" Type="http://schemas.openxmlformats.org/officeDocument/2006/relationships/slide" Target="slides/slide30.xml"/><Relationship Id="rId34" Type="http://schemas.openxmlformats.org/officeDocument/2006/relationships/slide" Target="slides/slide31.xml"/><Relationship Id="rId35" Type="http://schemas.openxmlformats.org/officeDocument/2006/relationships/slide" Target="slides/slide32.xml"/><Relationship Id="rId36" Type="http://schemas.openxmlformats.org/officeDocument/2006/relationships/slide" Target="slides/slide33.xml"/><Relationship Id="rId37" Type="http://schemas.openxmlformats.org/officeDocument/2006/relationships/slide" Target="slides/slide34.xml"/><Relationship Id="rId38" Type="http://schemas.openxmlformats.org/officeDocument/2006/relationships/slide" Target="slides/slide35.xml"/><Relationship Id="rId39" Type="http://schemas.openxmlformats.org/officeDocument/2006/relationships/slide" Target="slides/slide36.xml"/><Relationship Id="rId40" Type="http://schemas.openxmlformats.org/officeDocument/2006/relationships/slide" Target="slides/slide37.xml"/><Relationship Id="rId41" Type="http://schemas.openxmlformats.org/officeDocument/2006/relationships/slide" Target="slides/slide38.xml"/><Relationship Id="rId42" Type="http://schemas.openxmlformats.org/officeDocument/2006/relationships/slide" Target="slides/slide39.xml"/><Relationship Id="rId43" Type="http://schemas.openxmlformats.org/officeDocument/2006/relationships/slide" Target="slides/slide40.xml"/><Relationship Id="rId44" Type="http://schemas.openxmlformats.org/officeDocument/2006/relationships/slide" Target="slides/slide41.xml"/><Relationship Id="rId45" Type="http://schemas.openxmlformats.org/officeDocument/2006/relationships/slide" Target="slides/slide42.xml"/><Relationship Id="rId46" Type="http://schemas.openxmlformats.org/officeDocument/2006/relationships/slide" Target="slides/slide43.xml"/><Relationship Id="rId47" Type="http://schemas.openxmlformats.org/officeDocument/2006/relationships/slide" Target="slides/slide44.xml"/><Relationship Id="rId48" Type="http://schemas.openxmlformats.org/officeDocument/2006/relationships/slide" Target="slides/slide45.xml"/><Relationship Id="rId49" Type="http://schemas.openxmlformats.org/officeDocument/2006/relationships/slide" Target="slides/slide46.xml"/><Relationship Id="rId50" Type="http://schemas.openxmlformats.org/officeDocument/2006/relationships/slide" Target="slides/slide47.xml"/><Relationship Id="rId51" Type="http://schemas.openxmlformats.org/officeDocument/2006/relationships/slide" Target="slides/slide48.xml"/><Relationship Id="rId52" Type="http://schemas.openxmlformats.org/officeDocument/2006/relationships/slide" Target="slides/slide49.xml"/><Relationship Id="rId53" Type="http://schemas.openxmlformats.org/officeDocument/2006/relationships/slide" Target="slides/slide50.xml"/><Relationship Id="rId54" Type="http://schemas.openxmlformats.org/officeDocument/2006/relationships/slide" Target="slides/slide51.xml"/><Relationship Id="rId55" Type="http://schemas.openxmlformats.org/officeDocument/2006/relationships/slide" Target="slides/slide52.xml"/><Relationship Id="rId56" Type="http://schemas.openxmlformats.org/officeDocument/2006/relationships/slide" Target="slides/slide53.xml"/><Relationship Id="rId57" Type="http://schemas.openxmlformats.org/officeDocument/2006/relationships/slide" Target="slides/slide54.xml"/><Relationship Id="rId58" Type="http://schemas.openxmlformats.org/officeDocument/2006/relationships/slide" Target="slides/slide55.xml"/><Relationship Id="rId59" Type="http://schemas.openxmlformats.org/officeDocument/2006/relationships/slide" Target="slides/slide56.xml"/><Relationship Id="rId60" Type="http://schemas.openxmlformats.org/officeDocument/2006/relationships/slide" Target="slides/slide57.xml"/><Relationship Id="rId61" Type="http://schemas.openxmlformats.org/officeDocument/2006/relationships/slide" Target="slides/slide58.xml"/><Relationship Id="rId62" Type="http://schemas.openxmlformats.org/officeDocument/2006/relationships/slide" Target="slides/slide59.xml"/><Relationship Id="rId63" Type="http://schemas.openxmlformats.org/officeDocument/2006/relationships/slide" Target="slides/slide60.xml"/><Relationship Id="rId64" Type="http://schemas.openxmlformats.org/officeDocument/2006/relationships/slide" Target="slides/slide61.xml"/><Relationship Id="rId65" Type="http://schemas.openxmlformats.org/officeDocument/2006/relationships/slide" Target="slides/slide62.xml"/><Relationship Id="rId66" Type="http://schemas.openxmlformats.org/officeDocument/2006/relationships/slide" Target="slides/slide63.xml"/><Relationship Id="rId67" Type="http://schemas.openxmlformats.org/officeDocument/2006/relationships/slide" Target="slides/slide64.xml"/><Relationship Id="rId68" Type="http://schemas.openxmlformats.org/officeDocument/2006/relationships/slide" Target="slides/slide65.xml"/><Relationship Id="rId69" Type="http://schemas.openxmlformats.org/officeDocument/2006/relationships/slide" Target="slides/slide66.xml"/><Relationship Id="rId70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14560" y="1142640"/>
            <a:ext cx="4628880" cy="3086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FAE3FE3-068C-430D-BD1B-488AA6121097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37.xml.rels><?xml version="1.0" encoding="UTF-8"?>
<Relationships xmlns="http://schemas.openxmlformats.org/package/2006/relationships"><Relationship Id="rId1" Type="http://schemas.openxmlformats.org/officeDocument/2006/relationships/slide" Target="../slides/slide37.xml"/><Relationship Id="rId2" Type="http://schemas.openxmlformats.org/officeDocument/2006/relationships/notesMaster" Target="../notesMasters/notesMaster1.xml"/>
</Relationships>
</file>

<file path=ppt/notesSlides/_rels/notesSlide64.xml.rels><?xml version="1.0" encoding="UTF-8"?>
<Relationships xmlns="http://schemas.openxmlformats.org/package/2006/relationships"><Relationship Id="rId1" Type="http://schemas.openxmlformats.org/officeDocument/2006/relationships/slide" Target="../slides/slide64.xml"/><Relationship Id="rId2" Type="http://schemas.openxmlformats.org/officeDocument/2006/relationships/notesMaster" Target="../notesMasters/notesMaster1.xml"/>
</Relationships>
</file>

<file path=ppt/notesSlides/notesSlide3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3" name="PlaceHolder 1"/>
          <p:cNvSpPr>
            <a:spLocks noGrp="1"/>
          </p:cNvSpPr>
          <p:nvPr>
            <p:ph type="sldImg"/>
          </p:nvPr>
        </p:nvSpPr>
        <p:spPr>
          <a:xfrm>
            <a:off x="1114560" y="1143000"/>
            <a:ext cx="4628880" cy="3086280"/>
          </a:xfrm>
          <a:prstGeom prst="rect">
            <a:avLst/>
          </a:prstGeom>
          <a:ln w="0">
            <a:noFill/>
          </a:ln>
        </p:spPr>
      </p:sp>
      <p:sp>
        <p:nvSpPr>
          <p:cNvPr id="254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5" name="Slide Number Placeholder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FAC2C0B-4C6E-4B9D-9173-71C34DAB5491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6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6" name="PlaceHolder 1"/>
          <p:cNvSpPr>
            <a:spLocks noGrp="1"/>
          </p:cNvSpPr>
          <p:nvPr>
            <p:ph type="sldImg"/>
          </p:nvPr>
        </p:nvSpPr>
        <p:spPr>
          <a:xfrm>
            <a:off x="1114560" y="1143000"/>
            <a:ext cx="4628880" cy="3086280"/>
          </a:xfrm>
          <a:prstGeom prst="rect">
            <a:avLst/>
          </a:prstGeom>
          <a:ln w="0">
            <a:noFill/>
          </a:ln>
        </p:spPr>
      </p:sp>
      <p:sp>
        <p:nvSpPr>
          <p:cNvPr id="257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8" name="Slide Number Placeholder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0CABB0C-BE68-4365-A6D1-FE3962900F72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401C42-00E6-4709-9B27-F7812DF2141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080" y="1600200"/>
            <a:ext cx="925812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080" y="3964320"/>
            <a:ext cx="925812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CD2B77-DDEF-4F29-A123-6F9B68609D3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080" y="1600200"/>
            <a:ext cx="4517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258160" y="1600200"/>
            <a:ext cx="4517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080" y="3964320"/>
            <a:ext cx="4517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258160" y="3964320"/>
            <a:ext cx="4517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12A326-A2A1-4E7A-81A7-543F710F807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080" y="1600200"/>
            <a:ext cx="2980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644280" y="1600200"/>
            <a:ext cx="2980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774480" y="1600200"/>
            <a:ext cx="2980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080" y="3964320"/>
            <a:ext cx="2980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644280" y="3964320"/>
            <a:ext cx="2980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774480" y="3964320"/>
            <a:ext cx="2980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448B44-6A55-4B10-85BD-FA6C5A11FCC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080" y="1600200"/>
            <a:ext cx="925812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FF198E-3F11-470F-A05F-DB056F9218D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080" y="1600200"/>
            <a:ext cx="925812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2BDD7C-82C0-4CE4-8A66-FEF3467B95F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080" y="1600200"/>
            <a:ext cx="451764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258160" y="1600200"/>
            <a:ext cx="451764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5384C0-34AD-41F7-ABCB-8919C4C0A70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54F463-F22D-4AA8-A43F-8693A8DC667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080" y="274320"/>
            <a:ext cx="925812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DC419C-9366-4482-BEB1-805C3F2AE0C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080" y="1600200"/>
            <a:ext cx="4517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258160" y="1600200"/>
            <a:ext cx="451764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080" y="3964320"/>
            <a:ext cx="4517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8D17BF-61F6-4AEA-9FC0-737745530CA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080" y="1600200"/>
            <a:ext cx="451764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258160" y="1600200"/>
            <a:ext cx="4517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258160" y="3964320"/>
            <a:ext cx="4517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BC779E-877C-4FB7-83C2-B459198C8C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080" y="1600200"/>
            <a:ext cx="4517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258160" y="1600200"/>
            <a:ext cx="4517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080" y="3964320"/>
            <a:ext cx="925812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F1DAB1-1C5D-4031-83AD-D54A600FC35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080" y="1600200"/>
            <a:ext cx="925812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6356520"/>
            <a:ext cx="24001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514320" y="6356520"/>
            <a:ext cx="32576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372080" y="6356520"/>
            <a:ext cx="24001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C46C8F6-0BCD-4B49-8EDA-A8117937E27D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image" Target="../media/image4.jpeg"/><Relationship Id="rId3" Type="http://schemas.openxmlformats.org/officeDocument/2006/relationships/image" Target="../media/image5.jpeg"/><Relationship Id="rId4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7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2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0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1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5.xml.rels><?xml version="1.0" encoding="UTF-8"?>
<Relationships xmlns="http://schemas.openxmlformats.org/package/2006/relationships"><Relationship Id="rId1" Type="http://schemas.openxmlformats.org/officeDocument/2006/relationships/image" Target="../media/image6.jpe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3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7.xml"/>
</Relationships>
</file>

<file path=ppt/slides/_rels/slide3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9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0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3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4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7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4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50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51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5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5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5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55.xml.rels><?xml version="1.0" encoding="UTF-8"?>
<Relationships xmlns="http://schemas.openxmlformats.org/package/2006/relationships"><Relationship Id="rId1" Type="http://schemas.openxmlformats.org/officeDocument/2006/relationships/image" Target="../media/image7.jpeg"/><Relationship Id="rId2" Type="http://schemas.openxmlformats.org/officeDocument/2006/relationships/slideLayout" Target="../slideLayouts/slideLayout1.xml"/>
</Relationships>
</file>

<file path=ppt/slides/_rels/slide5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5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5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59.xml.rels><?xml version="1.0" encoding="UTF-8"?>
<Relationships xmlns="http://schemas.openxmlformats.org/package/2006/relationships"><Relationship Id="rId1" Type="http://schemas.openxmlformats.org/officeDocument/2006/relationships/image" Target="../media/image8.jpe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60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6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6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6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6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64.xml"/>
</Relationships>
</file>

<file path=ppt/slides/_rels/slide6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6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771120" y="2130120"/>
            <a:ext cx="8744040" cy="1469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Results 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 type="subTitle"/>
          </p:nvPr>
        </p:nvSpPr>
        <p:spPr>
          <a:xfrm>
            <a:off x="1542600" y="3886200"/>
            <a:ext cx="720108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898989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PlaceHolder 1"/>
          <p:cNvSpPr>
            <a:spLocks noGrp="1"/>
          </p:cNvSpPr>
          <p:nvPr>
            <p:ph type="title"/>
          </p:nvPr>
        </p:nvSpPr>
        <p:spPr>
          <a:xfrm>
            <a:off x="577800" y="4487400"/>
            <a:ext cx="8369280" cy="15066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Fishing community – Control methods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37" name=""/>
          <p:cNvGraphicFramePr/>
          <p:nvPr/>
        </p:nvGraphicFramePr>
        <p:xfrm>
          <a:off x="701640" y="487440"/>
          <a:ext cx="7551720" cy="4565520"/>
        </p:xfrm>
        <a:graphic>
          <a:graphicData uri="http://schemas.openxmlformats.org/drawingml/2006/table">
            <a:tbl>
              <a:tblPr/>
              <a:tblGrid>
                <a:gridCol w="7551720"/>
              </a:tblGrid>
              <a:tr h="4565520">
                <a:tc>
                  <a:txBody>
                    <a:bodyPr lIns="57960" rIns="57960" tIns="0" bIns="0" anchor="t">
                      <a:noAutofit/>
                    </a:bodyPr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ffffff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8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Restriction of availability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ffffff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8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Advice by priest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ffffff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8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Individual health education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ffffff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8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Use victim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ffffff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8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Display of boards at junctions and road-ends of the fishing village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ffffff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8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Display of billboards at fishing site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ffffff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8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Awareness programmes for fishing societies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8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 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960" marR="579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fcd5b5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8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2. Estate workers 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39" name="" descr=""/>
          <p:cNvPicPr/>
          <p:nvPr/>
        </p:nvPicPr>
        <p:blipFill>
          <a:blip r:embed="rId1"/>
          <a:stretch/>
        </p:blipFill>
        <p:spPr>
          <a:xfrm>
            <a:off x="514080" y="1600200"/>
            <a:ext cx="9258120" cy="4525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Estate workers - determinants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41" name=""/>
          <p:cNvGraphicFramePr/>
          <p:nvPr/>
        </p:nvGraphicFramePr>
        <p:xfrm>
          <a:off x="577800" y="655560"/>
          <a:ext cx="7201080" cy="5180040"/>
        </p:xfrm>
        <a:graphic>
          <a:graphicData uri="http://schemas.openxmlformats.org/drawingml/2006/table">
            <a:tbl>
              <a:tblPr/>
              <a:tblGrid>
                <a:gridCol w="7201080"/>
              </a:tblGrid>
              <a:tr h="5213160">
                <a:tc>
                  <a:txBody>
                    <a:bodyPr lIns="96480" rIns="96480" tIns="0" bIns="0" anchor="t">
                      <a:noAutofit/>
                    </a:bodyPr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 break monotony while working / lonely  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 maintain company with others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et stimulated by peers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etness / dampness due to rain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 remove leeches 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 tolerate bad smell due to ‘Ottapalu’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duces passing stools 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3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6480" marR="96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Calibri"/>
              </a:rPr>
              <a:t>Estate workers - Communication methods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43" name=""/>
          <p:cNvGraphicFramePr/>
          <p:nvPr/>
        </p:nvGraphicFramePr>
        <p:xfrm>
          <a:off x="531720" y="949320"/>
          <a:ext cx="7201080" cy="2571840"/>
        </p:xfrm>
        <a:graphic>
          <a:graphicData uri="http://schemas.openxmlformats.org/drawingml/2006/table">
            <a:tbl>
              <a:tblPr/>
              <a:tblGrid>
                <a:gridCol w="7201080"/>
              </a:tblGrid>
              <a:tr h="2606760">
                <a:tc>
                  <a:txBody>
                    <a:bodyPr lIns="96480" rIns="96480" tIns="0" bIns="0" anchor="t">
                      <a:noAutofit/>
                    </a:bodyPr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lliterate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o not read newspapers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 radio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atch TV – Shakthi, Sirasa (tele dramas)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6480" marR="96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4" name="PlaceHolder 1"/>
          <p:cNvSpPr>
            <a:spLocks noGrp="1"/>
          </p:cNvSpPr>
          <p:nvPr>
            <p:ph type="title"/>
          </p:nvPr>
        </p:nvSpPr>
        <p:spPr>
          <a:xfrm>
            <a:off x="577440" y="4487400"/>
            <a:ext cx="7823160" cy="15066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Estate workers – Control methods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45" name=""/>
          <p:cNvGraphicFramePr/>
          <p:nvPr/>
        </p:nvGraphicFramePr>
        <p:xfrm>
          <a:off x="685800" y="488880"/>
          <a:ext cx="7201080" cy="4565880"/>
        </p:xfrm>
        <a:graphic>
          <a:graphicData uri="http://schemas.openxmlformats.org/drawingml/2006/table">
            <a:tbl>
              <a:tblPr/>
              <a:tblGrid>
                <a:gridCol w="7201080"/>
              </a:tblGrid>
              <a:tr h="4565880">
                <a:tc>
                  <a:txBody>
                    <a:bodyPr lIns="96480" rIns="96480" tIns="0" bIns="0" anchor="t">
                      <a:noAutofit/>
                    </a:bodyPr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dvice through religious leaders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ele drama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oster display in public place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ouse to house visit &amp; individual education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rrange programmes for a gathering of all workers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creening of mouth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spcAft>
                          <a:spcPts val="799"/>
                        </a:spcAft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estriction of sale and consumption of betel quid at work site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6480" marR="96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6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3. Gem mine workers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47" name="Content Placeholder 3" descr=""/>
          <p:cNvPicPr/>
          <p:nvPr/>
        </p:nvPicPr>
        <p:blipFill>
          <a:blip r:embed="rId1"/>
          <a:stretch/>
        </p:blipFill>
        <p:spPr>
          <a:xfrm>
            <a:off x="1289160" y="2130480"/>
            <a:ext cx="2287440" cy="3614760"/>
          </a:xfrm>
          <a:prstGeom prst="rect">
            <a:avLst/>
          </a:prstGeom>
          <a:ln w="0">
            <a:noFill/>
          </a:ln>
        </p:spPr>
      </p:pic>
      <p:pic>
        <p:nvPicPr>
          <p:cNvPr id="148" name="Picture 5" descr=""/>
          <p:cNvPicPr/>
          <p:nvPr/>
        </p:nvPicPr>
        <p:blipFill>
          <a:blip r:embed="rId2"/>
          <a:stretch/>
        </p:blipFill>
        <p:spPr>
          <a:xfrm>
            <a:off x="4005360" y="2687760"/>
            <a:ext cx="2836800" cy="2965320"/>
          </a:xfrm>
          <a:prstGeom prst="rect">
            <a:avLst/>
          </a:prstGeom>
          <a:ln w="0">
            <a:noFill/>
          </a:ln>
        </p:spPr>
      </p:pic>
      <p:pic>
        <p:nvPicPr>
          <p:cNvPr id="149" name="Picture 6" descr=""/>
          <p:cNvPicPr/>
          <p:nvPr/>
        </p:nvPicPr>
        <p:blipFill>
          <a:blip r:embed="rId3"/>
          <a:stretch/>
        </p:blipFill>
        <p:spPr>
          <a:xfrm>
            <a:off x="6935760" y="2786040"/>
            <a:ext cx="2836800" cy="2768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0" name="PlaceHolder 1"/>
          <p:cNvSpPr>
            <a:spLocks noGrp="1"/>
          </p:cNvSpPr>
          <p:nvPr>
            <p:ph type="title"/>
          </p:nvPr>
        </p:nvSpPr>
        <p:spPr>
          <a:xfrm>
            <a:off x="358920" y="5124600"/>
            <a:ext cx="7200720" cy="15062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Gem mine workers - determinants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51" name=""/>
          <p:cNvGraphicFramePr/>
          <p:nvPr/>
        </p:nvGraphicFramePr>
        <p:xfrm>
          <a:off x="358920" y="314280"/>
          <a:ext cx="8961120" cy="6461280"/>
        </p:xfrm>
        <a:graphic>
          <a:graphicData uri="http://schemas.openxmlformats.org/drawingml/2006/table">
            <a:tbl>
              <a:tblPr/>
              <a:tblGrid>
                <a:gridCol w="8961120"/>
              </a:tblGrid>
              <a:tr h="6487560">
                <a:tc>
                  <a:txBody>
                    <a:bodyPr lIns="96480" rIns="96480" tIns="0" bIns="0" anchor="t">
                      <a:noAutofit/>
                    </a:bodyPr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oneliness / away from home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 other entertainment / leisure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etel quid available at mines – only thing can be used in mine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et and cold environment, when consume betel quid – feel warm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 overcome unpleasant smell of mud in the mine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 overcome unpleasant taste inside mouth when in mine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 habit at work place – everybody chew- peer pressure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spcAft>
                          <a:spcPts val="799"/>
                        </a:spcAft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eed to chew after eating fish / seafood to overcome unpleasantness in mouth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spcAft>
                          <a:spcPts val="799"/>
                        </a:spcAft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leepines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6480" marR="96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Calibri"/>
              </a:rPr>
              <a:t>Gem mine workers - Communication methods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53" name=""/>
          <p:cNvGraphicFramePr/>
          <p:nvPr/>
        </p:nvGraphicFramePr>
        <p:xfrm>
          <a:off x="577800" y="1015920"/>
          <a:ext cx="7201080" cy="4280040"/>
        </p:xfrm>
        <a:graphic>
          <a:graphicData uri="http://schemas.openxmlformats.org/drawingml/2006/table">
            <a:tbl>
              <a:tblPr/>
              <a:tblGrid>
                <a:gridCol w="7201080"/>
              </a:tblGrid>
              <a:tr h="4308480">
                <a:tc>
                  <a:txBody>
                    <a:bodyPr lIns="96480" rIns="96480" tIns="0" bIns="0" anchor="t">
                      <a:noAutofit/>
                    </a:bodyPr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artially literate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hones only for calls - SMS / FB not effective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o not listen to radio very much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spcAft>
                          <a:spcPts val="799"/>
                        </a:spcAft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V – watch tele dramas when at home. Do not specify channels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spcAft>
                          <a:spcPts val="799"/>
                        </a:spcAft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ewspaper ads / notices – may be effective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spcAft>
                          <a:spcPts val="799"/>
                        </a:spcAft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6480" marR="96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4" name="PlaceHolder 1"/>
          <p:cNvSpPr>
            <a:spLocks noGrp="1"/>
          </p:cNvSpPr>
          <p:nvPr>
            <p:ph type="title"/>
          </p:nvPr>
        </p:nvSpPr>
        <p:spPr>
          <a:xfrm>
            <a:off x="577800" y="4487400"/>
            <a:ext cx="8197920" cy="15066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Gem mine workers - Control methods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55" name=""/>
          <p:cNvGraphicFramePr/>
          <p:nvPr/>
        </p:nvGraphicFramePr>
        <p:xfrm>
          <a:off x="966960" y="1290600"/>
          <a:ext cx="6935760" cy="3197160"/>
        </p:xfrm>
        <a:graphic>
          <a:graphicData uri="http://schemas.openxmlformats.org/drawingml/2006/table">
            <a:tbl>
              <a:tblPr/>
              <a:tblGrid>
                <a:gridCol w="6935760"/>
              </a:tblGrid>
              <a:tr h="3197160">
                <a:tc>
                  <a:txBody>
                    <a:bodyPr lIns="57960" rIns="57960" tIns="0" bIns="0" anchor="t">
                      <a:noAutofit/>
                    </a:bodyPr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ffffff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Bring in regulation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ffffff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Impose fine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ffffff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Block the supply chain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ffffff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Awareness programmes at workplace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ffffff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Awareness Programmes in temples / religious places where people gather 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960" marR="579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6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4. Three wheeler drivers  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57" name="" descr=""/>
          <p:cNvPicPr/>
          <p:nvPr/>
        </p:nvPicPr>
        <p:blipFill>
          <a:blip r:embed="rId1"/>
          <a:stretch/>
        </p:blipFill>
        <p:spPr>
          <a:xfrm>
            <a:off x="514080" y="1600200"/>
            <a:ext cx="9258120" cy="4525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0" name="Group 2"/>
          <p:cNvGrpSpPr/>
          <p:nvPr/>
        </p:nvGrpSpPr>
        <p:grpSpPr>
          <a:xfrm>
            <a:off x="631800" y="406440"/>
            <a:ext cx="6536880" cy="6451560"/>
            <a:chOff x="631800" y="406440"/>
            <a:chExt cx="6536880" cy="6451560"/>
          </a:xfrm>
        </p:grpSpPr>
        <p:sp>
          <p:nvSpPr>
            <p:cNvPr id="51" name="Rectangle 375"/>
            <p:cNvSpPr/>
            <p:nvPr/>
          </p:nvSpPr>
          <p:spPr>
            <a:xfrm>
              <a:off x="907920" y="412560"/>
              <a:ext cx="1682280" cy="981000"/>
            </a:xfrm>
            <a:prstGeom prst="rect">
              <a:avLst/>
            </a:prstGeom>
            <a:solidFill>
              <a:srgbClr val="5b9bd5"/>
            </a:solidFill>
            <a:ln w="1260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just">
                <a:lnSpc>
                  <a:spcPct val="100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Availability at home garden at no cost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373"/>
            <p:cNvSpPr/>
            <p:nvPr/>
          </p:nvSpPr>
          <p:spPr>
            <a:xfrm>
              <a:off x="4940280" y="406440"/>
              <a:ext cx="1823400" cy="993600"/>
            </a:xfrm>
            <a:prstGeom prst="rect">
              <a:avLst/>
            </a:prstGeom>
            <a:solidFill>
              <a:srgbClr val="5b9bd5"/>
            </a:solidFill>
            <a:ln w="1260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oneliness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397"/>
            <p:cNvSpPr/>
            <p:nvPr/>
          </p:nvSpPr>
          <p:spPr>
            <a:xfrm>
              <a:off x="663840" y="1666800"/>
              <a:ext cx="1720440" cy="1084680"/>
            </a:xfrm>
            <a:prstGeom prst="rect">
              <a:avLst/>
            </a:prstGeom>
            <a:solidFill>
              <a:srgbClr val="5b9bd5"/>
            </a:solidFill>
            <a:ln w="1260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Peer pressure / Induced by peers / to maintain company with others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Rectangle 396"/>
            <p:cNvSpPr/>
            <p:nvPr/>
          </p:nvSpPr>
          <p:spPr>
            <a:xfrm>
              <a:off x="5261400" y="1666800"/>
              <a:ext cx="1900800" cy="1117440"/>
            </a:xfrm>
            <a:prstGeom prst="rect">
              <a:avLst/>
            </a:prstGeom>
            <a:solidFill>
              <a:srgbClr val="5b9bd5"/>
            </a:solidFill>
            <a:ln w="1260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.  Energize / improve efficiency / reduce laziness / reduce tiredness / improve alertness / </a:t>
              </a:r>
              <a:r>
                <a:rPr b="0" lang="en-GB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improve concentration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376"/>
            <p:cNvSpPr/>
            <p:nvPr/>
          </p:nvSpPr>
          <p:spPr>
            <a:xfrm>
              <a:off x="631800" y="2907000"/>
              <a:ext cx="1707120" cy="1000800"/>
            </a:xfrm>
            <a:prstGeom prst="rect">
              <a:avLst/>
            </a:prstGeom>
            <a:solidFill>
              <a:srgbClr val="5b9bd5"/>
            </a:solidFill>
            <a:ln w="1260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To break monotony of work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395"/>
            <p:cNvSpPr/>
            <p:nvPr/>
          </p:nvSpPr>
          <p:spPr>
            <a:xfrm>
              <a:off x="5274360" y="2887920"/>
              <a:ext cx="1894320" cy="1104480"/>
            </a:xfrm>
            <a:prstGeom prst="rect">
              <a:avLst/>
            </a:prstGeom>
            <a:solidFill>
              <a:srgbClr val="5b9bd5"/>
            </a:solidFill>
            <a:ln w="1260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on’t feel hunger delay meals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ectangle 394"/>
            <p:cNvSpPr/>
            <p:nvPr/>
          </p:nvSpPr>
          <p:spPr>
            <a:xfrm>
              <a:off x="670320" y="4109760"/>
              <a:ext cx="1721160" cy="961560"/>
            </a:xfrm>
            <a:prstGeom prst="rect">
              <a:avLst/>
            </a:prstGeom>
            <a:solidFill>
              <a:srgbClr val="5b9bd5"/>
            </a:solidFill>
            <a:ln w="1260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To counteract unpleasant smell / taste / feel freshness in mouth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393"/>
            <p:cNvSpPr/>
            <p:nvPr/>
          </p:nvSpPr>
          <p:spPr>
            <a:xfrm>
              <a:off x="5280840" y="4122720"/>
              <a:ext cx="1887480" cy="994320"/>
            </a:xfrm>
            <a:prstGeom prst="rect">
              <a:avLst/>
            </a:prstGeom>
            <a:solidFill>
              <a:srgbClr val="5b9bd5"/>
            </a:solidFill>
            <a:ln w="1260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>
                <a:lnSpc>
                  <a:spcPct val="100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To keep away leaches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Rectangle 392"/>
            <p:cNvSpPr/>
            <p:nvPr/>
          </p:nvSpPr>
          <p:spPr>
            <a:xfrm>
              <a:off x="676440" y="5220720"/>
              <a:ext cx="1727280" cy="1305720"/>
            </a:xfrm>
            <a:prstGeom prst="rect">
              <a:avLst/>
            </a:prstGeom>
            <a:solidFill>
              <a:srgbClr val="5b9bd5"/>
            </a:solidFill>
            <a:ln w="1260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Wetness / Dampness / cold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391"/>
            <p:cNvSpPr/>
            <p:nvPr/>
          </p:nvSpPr>
          <p:spPr>
            <a:xfrm>
              <a:off x="5299920" y="5311800"/>
              <a:ext cx="1867680" cy="935280"/>
            </a:xfrm>
            <a:prstGeom prst="rect">
              <a:avLst/>
            </a:prstGeom>
            <a:solidFill>
              <a:srgbClr val="5b9bd5"/>
            </a:solidFill>
            <a:ln w="1260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Enjoy reflex of chewing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Rectangle 390"/>
            <p:cNvSpPr/>
            <p:nvPr/>
          </p:nvSpPr>
          <p:spPr>
            <a:xfrm>
              <a:off x="2551680" y="5994360"/>
              <a:ext cx="2631960" cy="863640"/>
            </a:xfrm>
            <a:prstGeom prst="rect">
              <a:avLst/>
            </a:prstGeom>
            <a:solidFill>
              <a:srgbClr val="5b9bd5"/>
            </a:solidFill>
            <a:ln w="1260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>
                <a:lnSpc>
                  <a:spcPct val="100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Sleepiness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Oval 389"/>
            <p:cNvSpPr/>
            <p:nvPr/>
          </p:nvSpPr>
          <p:spPr>
            <a:xfrm>
              <a:off x="2930400" y="2154240"/>
              <a:ext cx="1816920" cy="3359160"/>
            </a:xfrm>
            <a:prstGeom prst="ellipse">
              <a:avLst/>
            </a:prstGeom>
            <a:solidFill>
              <a:srgbClr val="5b9bd5"/>
            </a:solidFill>
            <a:ln w="1260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eterminants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63" name="Straight Arrow Connector 388"/>
            <p:cNvCxnSpPr/>
            <p:nvPr/>
          </p:nvCxnSpPr>
          <p:spPr>
            <a:xfrm flipV="1">
              <a:off x="3835440" y="1457640"/>
              <a:ext cx="1080" cy="676440"/>
            </a:xfrm>
            <a:prstGeom prst="straightConnector1">
              <a:avLst/>
            </a:prstGeom>
            <a:ln w="6480">
              <a:solidFill>
                <a:srgbClr val="5b9bd5"/>
              </a:solidFill>
              <a:miter/>
              <a:tailEnd len="med" type="triangle" w="med"/>
            </a:ln>
          </p:spPr>
        </p:cxnSp>
        <p:cxnSp>
          <p:nvCxnSpPr>
            <p:cNvPr id="64" name="Straight Arrow Connector 387"/>
            <p:cNvCxnSpPr/>
            <p:nvPr/>
          </p:nvCxnSpPr>
          <p:spPr>
            <a:xfrm flipV="1">
              <a:off x="4297680" y="1445040"/>
              <a:ext cx="848520" cy="903960"/>
            </a:xfrm>
            <a:prstGeom prst="straightConnector1">
              <a:avLst/>
            </a:prstGeom>
            <a:ln w="6480">
              <a:solidFill>
                <a:srgbClr val="5b9bd5"/>
              </a:solidFill>
              <a:miter/>
              <a:tailEnd len="med" type="triangle" w="med"/>
            </a:ln>
          </p:spPr>
        </p:cxnSp>
        <p:cxnSp>
          <p:nvCxnSpPr>
            <p:cNvPr id="65" name="Straight Arrow Connector 386"/>
            <p:cNvCxnSpPr/>
            <p:nvPr/>
          </p:nvCxnSpPr>
          <p:spPr>
            <a:xfrm flipH="1" flipV="1">
              <a:off x="2487240" y="1419480"/>
              <a:ext cx="803520" cy="1040400"/>
            </a:xfrm>
            <a:prstGeom prst="straightConnector1">
              <a:avLst/>
            </a:prstGeom>
            <a:ln w="6480">
              <a:solidFill>
                <a:srgbClr val="5b9bd5"/>
              </a:solidFill>
              <a:miter/>
              <a:tailEnd len="med" type="triangle" w="med"/>
            </a:ln>
          </p:spPr>
        </p:cxnSp>
        <p:cxnSp>
          <p:nvCxnSpPr>
            <p:cNvPr id="66" name="Straight Arrow Connector 385"/>
            <p:cNvCxnSpPr/>
            <p:nvPr/>
          </p:nvCxnSpPr>
          <p:spPr>
            <a:xfrm flipH="1" flipV="1">
              <a:off x="2415960" y="2309400"/>
              <a:ext cx="675000" cy="526680"/>
            </a:xfrm>
            <a:prstGeom prst="straightConnector1">
              <a:avLst/>
            </a:prstGeom>
            <a:ln w="6480">
              <a:solidFill>
                <a:srgbClr val="5b9bd5"/>
              </a:solidFill>
              <a:miter/>
              <a:tailEnd len="med" type="triangle" w="med"/>
            </a:ln>
          </p:spPr>
        </p:cxnSp>
        <p:cxnSp>
          <p:nvCxnSpPr>
            <p:cNvPr id="67" name="Straight Arrow Connector 384"/>
            <p:cNvCxnSpPr/>
            <p:nvPr/>
          </p:nvCxnSpPr>
          <p:spPr>
            <a:xfrm flipV="1">
              <a:off x="4669920" y="2334960"/>
              <a:ext cx="559080" cy="728280"/>
            </a:xfrm>
            <a:prstGeom prst="straightConnector1">
              <a:avLst/>
            </a:prstGeom>
            <a:ln w="6480">
              <a:solidFill>
                <a:srgbClr val="5b9bd5"/>
              </a:solidFill>
              <a:miter/>
              <a:tailEnd len="med" type="triangle" w="med"/>
            </a:ln>
          </p:spPr>
        </p:cxnSp>
        <p:cxnSp>
          <p:nvCxnSpPr>
            <p:cNvPr id="68" name="Straight Arrow Connector 383"/>
            <p:cNvCxnSpPr/>
            <p:nvPr/>
          </p:nvCxnSpPr>
          <p:spPr>
            <a:xfrm flipH="1" flipV="1">
              <a:off x="2403000" y="3583440"/>
              <a:ext cx="508320" cy="110880"/>
            </a:xfrm>
            <a:prstGeom prst="straightConnector1">
              <a:avLst/>
            </a:prstGeom>
            <a:ln w="6480">
              <a:solidFill>
                <a:srgbClr val="5b9bd5"/>
              </a:solidFill>
              <a:miter/>
              <a:tailEnd len="med" type="triangle" w="med"/>
            </a:ln>
          </p:spPr>
        </p:cxnSp>
        <p:cxnSp>
          <p:nvCxnSpPr>
            <p:cNvPr id="69" name="Straight Arrow Connector 382"/>
            <p:cNvCxnSpPr/>
            <p:nvPr/>
          </p:nvCxnSpPr>
          <p:spPr>
            <a:xfrm flipV="1">
              <a:off x="4772880" y="3505680"/>
              <a:ext cx="457200" cy="331560"/>
            </a:xfrm>
            <a:prstGeom prst="straightConnector1">
              <a:avLst/>
            </a:prstGeom>
            <a:ln w="6480">
              <a:solidFill>
                <a:srgbClr val="5b9bd5"/>
              </a:solidFill>
              <a:miter/>
              <a:tailEnd len="med" type="triangle" w="med"/>
            </a:ln>
          </p:spPr>
        </p:cxnSp>
        <p:cxnSp>
          <p:nvCxnSpPr>
            <p:cNvPr id="70" name="Straight Arrow Connector 381"/>
            <p:cNvCxnSpPr/>
            <p:nvPr/>
          </p:nvCxnSpPr>
          <p:spPr>
            <a:xfrm flipH="1">
              <a:off x="2409840" y="4499640"/>
              <a:ext cx="572400" cy="72000"/>
            </a:xfrm>
            <a:prstGeom prst="straightConnector1">
              <a:avLst/>
            </a:prstGeom>
            <a:ln w="6480">
              <a:solidFill>
                <a:srgbClr val="5b9bd5"/>
              </a:solidFill>
              <a:miter/>
              <a:tailEnd len="med" type="triangle" w="med"/>
            </a:ln>
          </p:spPr>
        </p:cxnSp>
        <p:cxnSp>
          <p:nvCxnSpPr>
            <p:cNvPr id="71" name="Straight Arrow Connector 380"/>
            <p:cNvCxnSpPr/>
            <p:nvPr/>
          </p:nvCxnSpPr>
          <p:spPr>
            <a:xfrm>
              <a:off x="4708800" y="4480200"/>
              <a:ext cx="545760" cy="279360"/>
            </a:xfrm>
            <a:prstGeom prst="straightConnector1">
              <a:avLst/>
            </a:prstGeom>
            <a:ln w="6480">
              <a:solidFill>
                <a:srgbClr val="5b9bd5"/>
              </a:solidFill>
              <a:miter/>
              <a:tailEnd len="med" type="triangle" w="med"/>
            </a:ln>
          </p:spPr>
        </p:cxnSp>
        <p:cxnSp>
          <p:nvCxnSpPr>
            <p:cNvPr id="72" name="Straight Arrow Connector 379"/>
            <p:cNvCxnSpPr/>
            <p:nvPr/>
          </p:nvCxnSpPr>
          <p:spPr>
            <a:xfrm flipH="1">
              <a:off x="2422800" y="5226840"/>
              <a:ext cx="866880" cy="461880"/>
            </a:xfrm>
            <a:prstGeom prst="straightConnector1">
              <a:avLst/>
            </a:prstGeom>
            <a:ln w="6480">
              <a:solidFill>
                <a:srgbClr val="5b9bd5"/>
              </a:solidFill>
              <a:miter/>
              <a:tailEnd len="med" type="triangle" w="med"/>
            </a:ln>
          </p:spPr>
        </p:cxnSp>
        <p:cxnSp>
          <p:nvCxnSpPr>
            <p:cNvPr id="73" name="Straight Arrow Connector 378"/>
            <p:cNvCxnSpPr/>
            <p:nvPr/>
          </p:nvCxnSpPr>
          <p:spPr>
            <a:xfrm>
              <a:off x="4465440" y="5090400"/>
              <a:ext cx="803520" cy="676440"/>
            </a:xfrm>
            <a:prstGeom prst="straightConnector1">
              <a:avLst/>
            </a:prstGeom>
            <a:ln w="6480">
              <a:solidFill>
                <a:srgbClr val="5b9bd5"/>
              </a:solidFill>
              <a:miter/>
              <a:tailEnd len="med" type="triangle" w="med"/>
            </a:ln>
          </p:spPr>
        </p:cxnSp>
        <p:cxnSp>
          <p:nvCxnSpPr>
            <p:cNvPr id="74" name="Straight Arrow Connector 377"/>
            <p:cNvCxnSpPr/>
            <p:nvPr/>
          </p:nvCxnSpPr>
          <p:spPr>
            <a:xfrm>
              <a:off x="3822840" y="5532480"/>
              <a:ext cx="6840" cy="455400"/>
            </a:xfrm>
            <a:prstGeom prst="straightConnector1">
              <a:avLst/>
            </a:prstGeom>
            <a:ln w="6480">
              <a:solidFill>
                <a:srgbClr val="5b9bd5"/>
              </a:solidFill>
              <a:miter/>
              <a:tailEnd len="med" type="triangle" w="med"/>
            </a:ln>
          </p:spPr>
        </p:cxn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8" name="PlaceHolder 1"/>
          <p:cNvSpPr>
            <a:spLocks noGrp="1"/>
          </p:cNvSpPr>
          <p:nvPr>
            <p:ph type="title"/>
          </p:nvPr>
        </p:nvSpPr>
        <p:spPr>
          <a:xfrm>
            <a:off x="577440" y="4487400"/>
            <a:ext cx="8680680" cy="15066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Three wheeler drivers - determinants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59" name=""/>
          <p:cNvGraphicFramePr/>
          <p:nvPr/>
        </p:nvGraphicFramePr>
        <p:xfrm>
          <a:off x="577800" y="2224080"/>
          <a:ext cx="7201080" cy="2282760"/>
        </p:xfrm>
        <a:graphic>
          <a:graphicData uri="http://schemas.openxmlformats.org/drawingml/2006/table">
            <a:tbl>
              <a:tblPr/>
              <a:tblGrid>
                <a:gridCol w="7201080"/>
              </a:tblGrid>
              <a:tr h="2282760">
                <a:tc>
                  <a:txBody>
                    <a:bodyPr lIns="96480" rIns="96480" tIns="0" bIns="0" anchor="t">
                      <a:noAutofit/>
                    </a:bodyPr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nergize – improve alertness when chew betel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leepiness - spitting action prevent falling into sleep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spcAft>
                          <a:spcPts val="799"/>
                        </a:spcAft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ounteract lazines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6480" marR="96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0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Calibri"/>
              </a:rPr>
              <a:t>Three wheeler drivers – communication methods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61" name=""/>
          <p:cNvGraphicFramePr/>
          <p:nvPr/>
        </p:nvGraphicFramePr>
        <p:xfrm>
          <a:off x="444600" y="1407960"/>
          <a:ext cx="7200720" cy="2740320"/>
        </p:xfrm>
        <a:graphic>
          <a:graphicData uri="http://schemas.openxmlformats.org/drawingml/2006/table">
            <a:tbl>
              <a:tblPr/>
              <a:tblGrid>
                <a:gridCol w="7200720"/>
              </a:tblGrid>
              <a:tr h="2740320">
                <a:tc>
                  <a:txBody>
                    <a:bodyPr lIns="96480" rIns="96480" tIns="0" bIns="0" anchor="t">
                      <a:noAutofit/>
                    </a:bodyPr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artially literate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ardly read newspaper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V / Radio (Sirasa / Derana after 8.00pm or later)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spcAft>
                          <a:spcPts val="799"/>
                        </a:spcAft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obile phones only for calls. No use of smart phone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6480" marR="96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2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Calibri"/>
              </a:rPr>
              <a:t>Three wheeler drivers – control methods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63" name=""/>
          <p:cNvGraphicFramePr/>
          <p:nvPr/>
        </p:nvGraphicFramePr>
        <p:xfrm>
          <a:off x="577800" y="1930320"/>
          <a:ext cx="7201080" cy="1540080"/>
        </p:xfrm>
        <a:graphic>
          <a:graphicData uri="http://schemas.openxmlformats.org/drawingml/2006/table">
            <a:tbl>
              <a:tblPr/>
              <a:tblGrid>
                <a:gridCol w="7201080"/>
              </a:tblGrid>
              <a:tr h="1540080">
                <a:tc>
                  <a:txBody>
                    <a:bodyPr lIns="96480" rIns="96480" tIns="0" bIns="0" anchor="t">
                      <a:noAutofit/>
                    </a:bodyPr>
                    <a:p>
                      <a:pPr marL="343080" indent="-343080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nforcement of law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osters / stickers on consequences of ST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>
                        <a:lnSpc>
                          <a:spcPct val="107000"/>
                        </a:lnSpc>
                        <a:spcAft>
                          <a:spcPts val="799"/>
                        </a:spcAft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se of victims – live programme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6480" marR="96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5. Urban youth 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"/>
          <p:cNvSpPr txBox="1"/>
          <p:nvPr/>
        </p:nvSpPr>
        <p:spPr>
          <a:xfrm>
            <a:off x="514080" y="1600200"/>
            <a:ext cx="925812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6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Urban youth – Determinants 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67" name=""/>
          <p:cNvGraphicFramePr/>
          <p:nvPr/>
        </p:nvGraphicFramePr>
        <p:xfrm>
          <a:off x="476280" y="1139760"/>
          <a:ext cx="7200720" cy="3652920"/>
        </p:xfrm>
        <a:graphic>
          <a:graphicData uri="http://schemas.openxmlformats.org/drawingml/2006/table">
            <a:tbl>
              <a:tblPr/>
              <a:tblGrid>
                <a:gridCol w="7200720"/>
              </a:tblGrid>
              <a:tr h="3652920">
                <a:tc>
                  <a:txBody>
                    <a:bodyPr lIns="96480" rIns="96480" tIns="0" bIns="0" anchor="t">
                      <a:noAutofit/>
                    </a:bodyPr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eer Pressure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 get energized to do work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LT is freely available at home &amp; used by other family member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duced by availability at funeral houses – use to spend sleepless night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duce Sleep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6480" marR="96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8" name="PlaceHolder 1"/>
          <p:cNvSpPr>
            <a:spLocks noGrp="1"/>
          </p:cNvSpPr>
          <p:nvPr>
            <p:ph type="title"/>
          </p:nvPr>
        </p:nvSpPr>
        <p:spPr>
          <a:xfrm>
            <a:off x="537840" y="5097600"/>
            <a:ext cx="8853480" cy="15062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Urban youth – communication methods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69" name=""/>
          <p:cNvGraphicFramePr/>
          <p:nvPr/>
        </p:nvGraphicFramePr>
        <p:xfrm>
          <a:off x="577800" y="344520"/>
          <a:ext cx="8852040" cy="4989600"/>
        </p:xfrm>
        <a:graphic>
          <a:graphicData uri="http://schemas.openxmlformats.org/drawingml/2006/table">
            <a:tbl>
              <a:tblPr/>
              <a:tblGrid>
                <a:gridCol w="8852040"/>
              </a:tblGrid>
              <a:tr h="5017680">
                <a:tc>
                  <a:txBody>
                    <a:bodyPr lIns="96480" rIns="96480" tIns="0" bIns="0" anchor="t">
                      <a:noAutofit/>
                    </a:bodyPr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iterate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se Smart Phones (Facebook, Instagram)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MS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V (Hiru, Derana, Nethra,Sirasa, Shakthi)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adio (Hiru, Neth, Yfm, Shaa, Derana, Sooriyan, Shakthi,)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You tube (Watch Ads without skipping) - Use Girls / actresses (Pooja Uma Shankar..etc)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et information from friend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 use of Leaflets, Poster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spcAft>
                          <a:spcPts val="799"/>
                        </a:spcAft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atch Tamil Films.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6480" marR="96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0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Urban youth – control methods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71" name=""/>
          <p:cNvGraphicFramePr/>
          <p:nvPr/>
        </p:nvGraphicFramePr>
        <p:xfrm>
          <a:off x="554040" y="501480"/>
          <a:ext cx="7200720" cy="5445360"/>
        </p:xfrm>
        <a:graphic>
          <a:graphicData uri="http://schemas.openxmlformats.org/drawingml/2006/table">
            <a:tbl>
              <a:tblPr/>
              <a:tblGrid>
                <a:gridCol w="7200720"/>
              </a:tblGrid>
              <a:tr h="5473800">
                <a:tc>
                  <a:txBody>
                    <a:bodyPr lIns="96480" rIns="96480" tIns="0" bIns="0" anchor="t">
                      <a:noAutofit/>
                    </a:bodyPr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crease Price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ontrol availability around school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acebook and Social Media Campaign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how health effects of ST in media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ealth promotion programmes at village level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ducate Grade 8,9 &amp;10 students on risk factors  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se victim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spcAft>
                          <a:spcPts val="799"/>
                        </a:spcAft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ssages using girls in media – avoid pictures of patient with disfigured appearance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6480" marR="96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2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6. Construction site workers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73" name="" descr=""/>
          <p:cNvPicPr/>
          <p:nvPr/>
        </p:nvPicPr>
        <p:blipFill>
          <a:blip r:embed="rId1"/>
          <a:stretch/>
        </p:blipFill>
        <p:spPr>
          <a:xfrm>
            <a:off x="514080" y="1600200"/>
            <a:ext cx="9258120" cy="4525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Calibri"/>
              </a:rPr>
              <a:t>Construction site workers – Determinants 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75" name=""/>
          <p:cNvGraphicFramePr/>
          <p:nvPr/>
        </p:nvGraphicFramePr>
        <p:xfrm>
          <a:off x="577800" y="655560"/>
          <a:ext cx="7201080" cy="3832200"/>
        </p:xfrm>
        <a:graphic>
          <a:graphicData uri="http://schemas.openxmlformats.org/drawingml/2006/table">
            <a:tbl>
              <a:tblPr/>
              <a:tblGrid>
                <a:gridCol w="7201080"/>
              </a:tblGrid>
              <a:tr h="3832200">
                <a:tc>
                  <a:txBody>
                    <a:bodyPr lIns="96480" rIns="96480" tIns="0" bIns="0" anchor="t">
                      <a:noAutofit/>
                    </a:bodyPr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mprove concentration at work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 maintain company with other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 boost energy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way from family – loneliness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irednes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azines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spcAft>
                          <a:spcPts val="799"/>
                        </a:spcAft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duced by consumption of peers – peer pressure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6480" marR="96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PlaceHolder 1"/>
          <p:cNvSpPr>
            <a:spLocks noGrp="1"/>
          </p:cNvSpPr>
          <p:nvPr>
            <p:ph type="title"/>
          </p:nvPr>
        </p:nvSpPr>
        <p:spPr>
          <a:xfrm>
            <a:off x="577440" y="4487400"/>
            <a:ext cx="8906040" cy="15066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onstruction site workers – communication methods 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77" name=""/>
          <p:cNvGraphicFramePr/>
          <p:nvPr/>
        </p:nvGraphicFramePr>
        <p:xfrm>
          <a:off x="577800" y="920880"/>
          <a:ext cx="8423280" cy="4076640"/>
        </p:xfrm>
        <a:graphic>
          <a:graphicData uri="http://schemas.openxmlformats.org/drawingml/2006/table">
            <a:tbl>
              <a:tblPr/>
              <a:tblGrid>
                <a:gridCol w="8423280"/>
              </a:tblGrid>
              <a:tr h="4105440">
                <a:tc>
                  <a:txBody>
                    <a:bodyPr lIns="96480" rIns="96480" tIns="0" bIns="0" anchor="t">
                      <a:noAutofit/>
                    </a:bodyPr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artially literate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ardly use smart phones – phones only for telephone call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 newspapers at work site – do not read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V Channel best air time 7.30 pm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se Derana, Hiru)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afety Officer’s meeting at work site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spcAft>
                          <a:spcPts val="799"/>
                        </a:spcAft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hen developing communication tools, avoid disgusting picture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6480" marR="96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5" name="Group 2"/>
          <p:cNvGrpSpPr/>
          <p:nvPr/>
        </p:nvGrpSpPr>
        <p:grpSpPr>
          <a:xfrm>
            <a:off x="784080" y="406440"/>
            <a:ext cx="6537600" cy="6451560"/>
            <a:chOff x="784080" y="406440"/>
            <a:chExt cx="6537600" cy="6451560"/>
          </a:xfrm>
        </p:grpSpPr>
        <p:sp>
          <p:nvSpPr>
            <p:cNvPr id="76" name="Rectangle 375"/>
            <p:cNvSpPr/>
            <p:nvPr/>
          </p:nvSpPr>
          <p:spPr>
            <a:xfrm>
              <a:off x="1060200" y="412560"/>
              <a:ext cx="1682280" cy="981000"/>
            </a:xfrm>
            <a:prstGeom prst="rect">
              <a:avLst/>
            </a:prstGeom>
            <a:solidFill>
              <a:srgbClr val="5b9bd5"/>
            </a:solidFill>
            <a:ln w="1260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Individual or group level awareness programmes (11</a:t>
              </a:r>
              <a:r>
                <a:rPr b="0" lang="en-GB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groups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Rectangle 373"/>
            <p:cNvSpPr/>
            <p:nvPr/>
          </p:nvSpPr>
          <p:spPr>
            <a:xfrm>
              <a:off x="5092560" y="406440"/>
              <a:ext cx="1823760" cy="993600"/>
            </a:xfrm>
            <a:prstGeom prst="rect">
              <a:avLst/>
            </a:prstGeom>
            <a:solidFill>
              <a:srgbClr val="5b9bd5"/>
            </a:solidFill>
            <a:ln w="1260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>
                <a:lnSpc>
                  <a:spcPct val="100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Urban youth and clerks, other groups are illiterate or partially literate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Rectangle 397"/>
            <p:cNvSpPr/>
            <p:nvPr/>
          </p:nvSpPr>
          <p:spPr>
            <a:xfrm>
              <a:off x="816120" y="1666800"/>
              <a:ext cx="1720440" cy="1084680"/>
            </a:xfrm>
            <a:prstGeom prst="rect">
              <a:avLst/>
            </a:prstGeom>
            <a:solidFill>
              <a:srgbClr val="5b9bd5"/>
            </a:solidFill>
            <a:ln w="1260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Only 4 groups reported listening to radio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ectangle 396"/>
            <p:cNvSpPr/>
            <p:nvPr/>
          </p:nvSpPr>
          <p:spPr>
            <a:xfrm>
              <a:off x="5413680" y="1666800"/>
              <a:ext cx="1900800" cy="1117440"/>
            </a:xfrm>
            <a:prstGeom prst="rect">
              <a:avLst/>
            </a:prstGeom>
            <a:solidFill>
              <a:srgbClr val="5b9bd5"/>
            </a:solidFill>
            <a:ln w="1260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1" lang="en-GB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All groups</a:t>
              </a:r>
              <a:r>
                <a:rPr b="0" lang="en-GB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1" lang="en-GB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watch TV at some time of day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Rectangle 376"/>
            <p:cNvSpPr/>
            <p:nvPr/>
          </p:nvSpPr>
          <p:spPr>
            <a:xfrm>
              <a:off x="784080" y="2907000"/>
              <a:ext cx="1707120" cy="1000800"/>
            </a:xfrm>
            <a:prstGeom prst="rect">
              <a:avLst/>
            </a:prstGeom>
            <a:solidFill>
              <a:srgbClr val="5b9bd5"/>
            </a:solidFill>
            <a:ln w="1260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Newspaper Ads – 2 group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395"/>
            <p:cNvSpPr/>
            <p:nvPr/>
          </p:nvSpPr>
          <p:spPr>
            <a:xfrm>
              <a:off x="5427000" y="2887920"/>
              <a:ext cx="1894680" cy="1104480"/>
            </a:xfrm>
            <a:prstGeom prst="rect">
              <a:avLst/>
            </a:prstGeom>
            <a:solidFill>
              <a:srgbClr val="5b9bd5"/>
            </a:solidFill>
            <a:ln w="1260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Use religious leaders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Rectangle 394"/>
            <p:cNvSpPr/>
            <p:nvPr/>
          </p:nvSpPr>
          <p:spPr>
            <a:xfrm>
              <a:off x="822600" y="4109760"/>
              <a:ext cx="1721160" cy="961560"/>
            </a:xfrm>
            <a:prstGeom prst="rect">
              <a:avLst/>
            </a:prstGeom>
            <a:solidFill>
              <a:srgbClr val="5b9bd5"/>
            </a:solidFill>
            <a:ln w="1260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>
                <a:lnSpc>
                  <a:spcPct val="100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Smart phones only urban youth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Rectangle 393"/>
            <p:cNvSpPr/>
            <p:nvPr/>
          </p:nvSpPr>
          <p:spPr>
            <a:xfrm>
              <a:off x="5433120" y="4122720"/>
              <a:ext cx="1887840" cy="994320"/>
            </a:xfrm>
            <a:prstGeom prst="rect">
              <a:avLst/>
            </a:prstGeom>
            <a:solidFill>
              <a:srgbClr val="5b9bd5"/>
            </a:solidFill>
            <a:ln w="1260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>
                <a:lnSpc>
                  <a:spcPct val="100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Billboards &amp; posters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Rectangle 392"/>
            <p:cNvSpPr/>
            <p:nvPr/>
          </p:nvSpPr>
          <p:spPr>
            <a:xfrm>
              <a:off x="828720" y="5220720"/>
              <a:ext cx="1727280" cy="1305720"/>
            </a:xfrm>
            <a:prstGeom prst="rect">
              <a:avLst/>
            </a:prstGeom>
            <a:solidFill>
              <a:srgbClr val="5b9bd5"/>
            </a:solidFill>
            <a:ln w="1260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News papers only 4 groups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Rectangle 391"/>
            <p:cNvSpPr/>
            <p:nvPr/>
          </p:nvSpPr>
          <p:spPr>
            <a:xfrm>
              <a:off x="5452560" y="5311800"/>
              <a:ext cx="1867680" cy="935280"/>
            </a:xfrm>
            <a:prstGeom prst="rect">
              <a:avLst/>
            </a:prstGeom>
            <a:solidFill>
              <a:srgbClr val="5b9bd5"/>
            </a:solidFill>
            <a:ln w="1260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lvl="1" marL="457200" algn="just">
                <a:lnSpc>
                  <a:spcPct val="100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TV Ads – 3 groups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Rectangle 390"/>
            <p:cNvSpPr/>
            <p:nvPr/>
          </p:nvSpPr>
          <p:spPr>
            <a:xfrm>
              <a:off x="2703960" y="5994360"/>
              <a:ext cx="2632320" cy="863640"/>
            </a:xfrm>
            <a:prstGeom prst="rect">
              <a:avLst/>
            </a:prstGeom>
            <a:solidFill>
              <a:srgbClr val="5b9bd5"/>
            </a:solidFill>
            <a:ln w="1260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>
                <a:lnSpc>
                  <a:spcPct val="100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Use victims</a:t>
              </a:r>
              <a:r>
                <a:rPr b="0" lang="en-GB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to deliver message to others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Oval 389"/>
            <p:cNvSpPr/>
            <p:nvPr/>
          </p:nvSpPr>
          <p:spPr>
            <a:xfrm>
              <a:off x="3082680" y="2154240"/>
              <a:ext cx="1817280" cy="3359160"/>
            </a:xfrm>
            <a:prstGeom prst="ellipse">
              <a:avLst/>
            </a:prstGeom>
            <a:solidFill>
              <a:srgbClr val="5b9bd5"/>
            </a:solidFill>
            <a:ln w="1260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Communication methods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88" name="Straight Arrow Connector 388"/>
            <p:cNvCxnSpPr/>
            <p:nvPr/>
          </p:nvCxnSpPr>
          <p:spPr>
            <a:xfrm flipV="1">
              <a:off x="3987720" y="1457640"/>
              <a:ext cx="1080" cy="676440"/>
            </a:xfrm>
            <a:prstGeom prst="straightConnector1">
              <a:avLst/>
            </a:prstGeom>
            <a:ln w="6480">
              <a:solidFill>
                <a:srgbClr val="5b9bd5"/>
              </a:solidFill>
              <a:miter/>
              <a:tailEnd len="med" type="triangle" w="med"/>
            </a:ln>
          </p:spPr>
        </p:cxnSp>
        <p:cxnSp>
          <p:nvCxnSpPr>
            <p:cNvPr id="89" name="Straight Arrow Connector 387"/>
            <p:cNvCxnSpPr/>
            <p:nvPr/>
          </p:nvCxnSpPr>
          <p:spPr>
            <a:xfrm flipV="1">
              <a:off x="4450320" y="1445040"/>
              <a:ext cx="848520" cy="903960"/>
            </a:xfrm>
            <a:prstGeom prst="straightConnector1">
              <a:avLst/>
            </a:prstGeom>
            <a:ln w="6480">
              <a:solidFill>
                <a:srgbClr val="5b9bd5"/>
              </a:solidFill>
              <a:miter/>
              <a:tailEnd len="med" type="triangle" w="med"/>
            </a:ln>
          </p:spPr>
        </p:cxnSp>
        <p:cxnSp>
          <p:nvCxnSpPr>
            <p:cNvPr id="90" name="Straight Arrow Connector 386"/>
            <p:cNvCxnSpPr/>
            <p:nvPr/>
          </p:nvCxnSpPr>
          <p:spPr>
            <a:xfrm flipH="1" flipV="1">
              <a:off x="2639520" y="1419480"/>
              <a:ext cx="803520" cy="1040400"/>
            </a:xfrm>
            <a:prstGeom prst="straightConnector1">
              <a:avLst/>
            </a:prstGeom>
            <a:ln w="6480">
              <a:solidFill>
                <a:srgbClr val="5b9bd5"/>
              </a:solidFill>
              <a:miter/>
              <a:tailEnd len="med" type="triangle" w="med"/>
            </a:ln>
          </p:spPr>
        </p:cxnSp>
        <p:cxnSp>
          <p:nvCxnSpPr>
            <p:cNvPr id="91" name="Straight Arrow Connector 385"/>
            <p:cNvCxnSpPr/>
            <p:nvPr/>
          </p:nvCxnSpPr>
          <p:spPr>
            <a:xfrm flipH="1" flipV="1">
              <a:off x="2568240" y="2309400"/>
              <a:ext cx="675000" cy="526680"/>
            </a:xfrm>
            <a:prstGeom prst="straightConnector1">
              <a:avLst/>
            </a:prstGeom>
            <a:ln w="6480">
              <a:solidFill>
                <a:srgbClr val="5b9bd5"/>
              </a:solidFill>
              <a:miter/>
              <a:tailEnd len="med" type="triangle" w="med"/>
            </a:ln>
          </p:spPr>
        </p:cxnSp>
        <p:cxnSp>
          <p:nvCxnSpPr>
            <p:cNvPr id="92" name="Straight Arrow Connector 384"/>
            <p:cNvCxnSpPr/>
            <p:nvPr/>
          </p:nvCxnSpPr>
          <p:spPr>
            <a:xfrm flipV="1">
              <a:off x="4822560" y="2334960"/>
              <a:ext cx="559080" cy="728280"/>
            </a:xfrm>
            <a:prstGeom prst="straightConnector1">
              <a:avLst/>
            </a:prstGeom>
            <a:ln w="6480">
              <a:solidFill>
                <a:srgbClr val="5b9bd5"/>
              </a:solidFill>
              <a:miter/>
              <a:tailEnd len="med" type="triangle" w="med"/>
            </a:ln>
          </p:spPr>
        </p:cxnSp>
        <p:cxnSp>
          <p:nvCxnSpPr>
            <p:cNvPr id="93" name="Straight Arrow Connector 383"/>
            <p:cNvCxnSpPr/>
            <p:nvPr/>
          </p:nvCxnSpPr>
          <p:spPr>
            <a:xfrm flipH="1" flipV="1">
              <a:off x="2555640" y="3583440"/>
              <a:ext cx="508320" cy="110880"/>
            </a:xfrm>
            <a:prstGeom prst="straightConnector1">
              <a:avLst/>
            </a:prstGeom>
            <a:ln w="6480">
              <a:solidFill>
                <a:srgbClr val="5b9bd5"/>
              </a:solidFill>
              <a:miter/>
              <a:tailEnd len="med" type="triangle" w="med"/>
            </a:ln>
          </p:spPr>
        </p:cxnSp>
        <p:cxnSp>
          <p:nvCxnSpPr>
            <p:cNvPr id="94" name="Straight Arrow Connector 382"/>
            <p:cNvCxnSpPr/>
            <p:nvPr/>
          </p:nvCxnSpPr>
          <p:spPr>
            <a:xfrm flipV="1">
              <a:off x="4925520" y="3505680"/>
              <a:ext cx="457200" cy="331560"/>
            </a:xfrm>
            <a:prstGeom prst="straightConnector1">
              <a:avLst/>
            </a:prstGeom>
            <a:ln w="6480">
              <a:solidFill>
                <a:srgbClr val="5b9bd5"/>
              </a:solidFill>
              <a:miter/>
              <a:tailEnd len="med" type="triangle" w="med"/>
            </a:ln>
          </p:spPr>
        </p:cxnSp>
        <p:cxnSp>
          <p:nvCxnSpPr>
            <p:cNvPr id="95" name="Straight Arrow Connector 381"/>
            <p:cNvCxnSpPr/>
            <p:nvPr/>
          </p:nvCxnSpPr>
          <p:spPr>
            <a:xfrm flipH="1">
              <a:off x="2562480" y="4499640"/>
              <a:ext cx="572400" cy="72000"/>
            </a:xfrm>
            <a:prstGeom prst="straightConnector1">
              <a:avLst/>
            </a:prstGeom>
            <a:ln w="6480">
              <a:solidFill>
                <a:srgbClr val="5b9bd5"/>
              </a:solidFill>
              <a:miter/>
              <a:tailEnd len="med" type="triangle" w="med"/>
            </a:ln>
          </p:spPr>
        </p:cxnSp>
        <p:cxnSp>
          <p:nvCxnSpPr>
            <p:cNvPr id="96" name="Straight Arrow Connector 380"/>
            <p:cNvCxnSpPr/>
            <p:nvPr/>
          </p:nvCxnSpPr>
          <p:spPr>
            <a:xfrm>
              <a:off x="4861440" y="4480200"/>
              <a:ext cx="545760" cy="279360"/>
            </a:xfrm>
            <a:prstGeom prst="straightConnector1">
              <a:avLst/>
            </a:prstGeom>
            <a:ln w="6480">
              <a:solidFill>
                <a:srgbClr val="5b9bd5"/>
              </a:solidFill>
              <a:miter/>
              <a:tailEnd len="med" type="triangle" w="med"/>
            </a:ln>
          </p:spPr>
        </p:cxnSp>
        <p:cxnSp>
          <p:nvCxnSpPr>
            <p:cNvPr id="97" name="Straight Arrow Connector 379"/>
            <p:cNvCxnSpPr/>
            <p:nvPr/>
          </p:nvCxnSpPr>
          <p:spPr>
            <a:xfrm flipH="1">
              <a:off x="2575080" y="5226840"/>
              <a:ext cx="866880" cy="461880"/>
            </a:xfrm>
            <a:prstGeom prst="straightConnector1">
              <a:avLst/>
            </a:prstGeom>
            <a:ln w="6480">
              <a:solidFill>
                <a:srgbClr val="5b9bd5"/>
              </a:solidFill>
              <a:miter/>
              <a:tailEnd len="med" type="triangle" w="med"/>
            </a:ln>
          </p:spPr>
        </p:cxnSp>
        <p:cxnSp>
          <p:nvCxnSpPr>
            <p:cNvPr id="98" name="Straight Arrow Connector 378"/>
            <p:cNvCxnSpPr/>
            <p:nvPr/>
          </p:nvCxnSpPr>
          <p:spPr>
            <a:xfrm>
              <a:off x="4617720" y="5090400"/>
              <a:ext cx="803520" cy="676440"/>
            </a:xfrm>
            <a:prstGeom prst="straightConnector1">
              <a:avLst/>
            </a:prstGeom>
            <a:ln w="6480">
              <a:solidFill>
                <a:srgbClr val="5b9bd5"/>
              </a:solidFill>
              <a:miter/>
              <a:tailEnd len="med" type="triangle" w="med"/>
            </a:ln>
          </p:spPr>
        </p:cxnSp>
        <p:cxnSp>
          <p:nvCxnSpPr>
            <p:cNvPr id="99" name="Straight Arrow Connector 377"/>
            <p:cNvCxnSpPr/>
            <p:nvPr/>
          </p:nvCxnSpPr>
          <p:spPr>
            <a:xfrm>
              <a:off x="3975120" y="5532480"/>
              <a:ext cx="6840" cy="455400"/>
            </a:xfrm>
            <a:prstGeom prst="straightConnector1">
              <a:avLst/>
            </a:prstGeom>
            <a:ln w="6480">
              <a:solidFill>
                <a:srgbClr val="5b9bd5"/>
              </a:solidFill>
              <a:miter/>
              <a:tailEnd len="med" type="triangle" w="med"/>
            </a:ln>
          </p:spPr>
        </p:cxn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Calibri"/>
              </a:rPr>
              <a:t>Construction site workers – control methods 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79" name=""/>
          <p:cNvGraphicFramePr/>
          <p:nvPr/>
        </p:nvGraphicFramePr>
        <p:xfrm>
          <a:off x="577800" y="890640"/>
          <a:ext cx="6608880" cy="3832200"/>
        </p:xfrm>
        <a:graphic>
          <a:graphicData uri="http://schemas.openxmlformats.org/drawingml/2006/table">
            <a:tbl>
              <a:tblPr/>
              <a:tblGrid>
                <a:gridCol w="6608880"/>
              </a:tblGrid>
              <a:tr h="3832200">
                <a:tc>
                  <a:txBody>
                    <a:bodyPr lIns="57960" rIns="57960" tIns="0" bIns="0" anchor="t">
                      <a:noAutofit/>
                    </a:bodyPr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ffffff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28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Legislation &amp; Law enforcement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ffffff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28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Fines (Fine - 500/=)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ffffff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28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Lectures at the Assembly Meeting in the Morning (by in-charge for safety)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ffffff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28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Use of victim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ffffff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28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Posters on the notice board (Pictures of victims, lesions)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>
                        <a:lnSpc>
                          <a:spcPct val="107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960" marR="579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0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7. MC Labourers 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81" name="" descr=""/>
          <p:cNvPicPr/>
          <p:nvPr/>
        </p:nvPicPr>
        <p:blipFill>
          <a:blip r:embed="rId1"/>
          <a:stretch/>
        </p:blipFill>
        <p:spPr>
          <a:xfrm>
            <a:off x="514080" y="1600200"/>
            <a:ext cx="9258120" cy="4525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Mc labourers – Determinants 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83" name=""/>
          <p:cNvGraphicFramePr/>
          <p:nvPr/>
        </p:nvGraphicFramePr>
        <p:xfrm>
          <a:off x="577800" y="1428840"/>
          <a:ext cx="7201080" cy="3195720"/>
        </p:xfrm>
        <a:graphic>
          <a:graphicData uri="http://schemas.openxmlformats.org/drawingml/2006/table">
            <a:tbl>
              <a:tblPr/>
              <a:tblGrid>
                <a:gridCol w="7201080"/>
              </a:tblGrid>
              <a:tr h="3195720">
                <a:tc>
                  <a:txBody>
                    <a:bodyPr lIns="96480" rIns="96480" tIns="0" bIns="0" anchor="t">
                      <a:noAutofit/>
                    </a:bodyPr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npleasant feeling in the mouth – garbage smell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npleasant taste in the mouth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onelines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on’t feel tired &amp; can work efficiently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leepines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spcAft>
                          <a:spcPts val="799"/>
                        </a:spcAft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njoy chewing relax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6480" marR="96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Calibri"/>
              </a:rPr>
              <a:t>Mc labourers - communication methods 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85" name=""/>
          <p:cNvGraphicFramePr/>
          <p:nvPr/>
        </p:nvGraphicFramePr>
        <p:xfrm>
          <a:off x="436680" y="1228680"/>
          <a:ext cx="7342200" cy="3652920"/>
        </p:xfrm>
        <a:graphic>
          <a:graphicData uri="http://schemas.openxmlformats.org/drawingml/2006/table">
            <a:tbl>
              <a:tblPr/>
              <a:tblGrid>
                <a:gridCol w="7342200"/>
              </a:tblGrid>
              <a:tr h="3652920">
                <a:tc>
                  <a:txBody>
                    <a:bodyPr lIns="96480" rIns="96480" tIns="0" bIns="0" anchor="t">
                      <a:noAutofit/>
                    </a:bodyPr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lliterate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o not read newspapers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t listen to radio,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obile phones only to take calls - not use smart phone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osters with pictures, photos 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spcAft>
                          <a:spcPts val="799"/>
                        </a:spcAft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V (Sirasa, Hiru, Derana, Shakthi - News time)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6480" marR="96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Mc labourers - control methods 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87" name=""/>
          <p:cNvGraphicFramePr/>
          <p:nvPr/>
        </p:nvGraphicFramePr>
        <p:xfrm>
          <a:off x="843120" y="1446120"/>
          <a:ext cx="7200720" cy="3652920"/>
        </p:xfrm>
        <a:graphic>
          <a:graphicData uri="http://schemas.openxmlformats.org/drawingml/2006/table">
            <a:tbl>
              <a:tblPr/>
              <a:tblGrid>
                <a:gridCol w="7200720"/>
              </a:tblGrid>
              <a:tr h="3652920">
                <a:tc>
                  <a:txBody>
                    <a:bodyPr lIns="96480" rIns="96480" tIns="0" bIns="0" anchor="t">
                      <a:noAutofit/>
                    </a:bodyPr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ome visit for individual education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se victims and doctors for education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ducate on law and enforce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ass message through religious leaders - temples / catholic church / Hindu kovil / mosque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V Advertisements at news time may be useful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6480" marR="96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8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8. Bus drivers and conductors 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89" name="Picture 4" descr="Image result for sri lanka private bus drivers and conductors"/>
          <p:cNvPicPr/>
          <p:nvPr/>
        </p:nvPicPr>
        <p:blipFill>
          <a:blip r:embed="rId1"/>
          <a:stretch/>
        </p:blipFill>
        <p:spPr>
          <a:xfrm>
            <a:off x="2800440" y="2052720"/>
            <a:ext cx="5178240" cy="4073400"/>
          </a:xfrm>
          <a:prstGeom prst="rect">
            <a:avLst/>
          </a:prstGeom>
          <a:ln w="0">
            <a:noFill/>
          </a:ln>
        </p:spPr>
      </p:pic>
      <p:pic>
        <p:nvPicPr>
          <p:cNvPr id="190" name="" descr=""/>
          <p:cNvPicPr/>
          <p:nvPr/>
        </p:nvPicPr>
        <p:blipFill>
          <a:blip r:embed="rId2"/>
          <a:stretch/>
        </p:blipFill>
        <p:spPr>
          <a:xfrm>
            <a:off x="514080" y="1600200"/>
            <a:ext cx="9258120" cy="4525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1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Calibri"/>
              </a:rPr>
              <a:t>Bus drivers and conductors – determinants 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92" name=""/>
          <p:cNvGraphicFramePr/>
          <p:nvPr/>
        </p:nvGraphicFramePr>
        <p:xfrm>
          <a:off x="577800" y="987480"/>
          <a:ext cx="7201080" cy="3652920"/>
        </p:xfrm>
        <a:graphic>
          <a:graphicData uri="http://schemas.openxmlformats.org/drawingml/2006/table">
            <a:tbl>
              <a:tblPr/>
              <a:tblGrid>
                <a:gridCol w="7201080"/>
              </a:tblGrid>
              <a:tr h="3652920">
                <a:tc>
                  <a:txBody>
                    <a:bodyPr lIns="96480" rIns="96480" tIns="0" bIns="0" anchor="t">
                      <a:noAutofit/>
                    </a:bodyPr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mprove alertnes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 break monotony of work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eel freshness in mouth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 counteract loneliness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 counteract sleepines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njoy chewing reflex – prevent sleepines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spcAft>
                          <a:spcPts val="799"/>
                        </a:spcAft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 compensate for hunger – can delay meals 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6480" marR="96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3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Calibri"/>
              </a:rPr>
              <a:t>Bus drivers and conductors –  communication methods 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94" name=""/>
          <p:cNvGraphicFramePr/>
          <p:nvPr/>
        </p:nvGraphicFramePr>
        <p:xfrm>
          <a:off x="577800" y="696960"/>
          <a:ext cx="7201080" cy="4076640"/>
        </p:xfrm>
        <a:graphic>
          <a:graphicData uri="http://schemas.openxmlformats.org/drawingml/2006/table">
            <a:tbl>
              <a:tblPr/>
              <a:tblGrid>
                <a:gridCol w="7201080"/>
              </a:tblGrid>
              <a:tr h="4105440">
                <a:tc>
                  <a:txBody>
                    <a:bodyPr lIns="96480" rIns="96480" tIns="0" bIns="0" anchor="t">
                      <a:noAutofit/>
                    </a:bodyPr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artially literate / illiterate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 newspaper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hone use only for calls - not use smart phone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V – Hiru, Derana, Sirasa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ickers in buse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ssages in CD or pen prives to display in TV fixed in bus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spcAft>
                          <a:spcPts val="799"/>
                        </a:spcAft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osters with pictures / photos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6480" marR="96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5" name="PlaceHolder 1"/>
          <p:cNvSpPr>
            <a:spLocks noGrp="1"/>
          </p:cNvSpPr>
          <p:nvPr>
            <p:ph type="title"/>
          </p:nvPr>
        </p:nvSpPr>
        <p:spPr>
          <a:xfrm>
            <a:off x="514440" y="5114520"/>
            <a:ext cx="7200720" cy="1508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Bus drivers and conductors –  control methods 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96" name=""/>
          <p:cNvGraphicFramePr/>
          <p:nvPr/>
        </p:nvGraphicFramePr>
        <p:xfrm>
          <a:off x="374760" y="582480"/>
          <a:ext cx="9421560" cy="5023080"/>
        </p:xfrm>
        <a:graphic>
          <a:graphicData uri="http://schemas.openxmlformats.org/drawingml/2006/table">
            <a:tbl>
              <a:tblPr/>
              <a:tblGrid>
                <a:gridCol w="9421560"/>
              </a:tblGrid>
              <a:tr h="5023080">
                <a:tc>
                  <a:txBody>
                    <a:bodyPr lIns="96480" rIns="96480" tIns="0" bIns="0" anchor="t">
                      <a:noAutofit/>
                    </a:bodyPr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estrict Supply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dividual Communication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isplay Material at Bus Park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ducate Children  (Primary Education)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illboards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oster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lean teeth at a Mobile Dental clinic with the promise to stop habit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icker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ublic Notice Board (Bus Stand)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spcAft>
                          <a:spcPts val="799"/>
                        </a:spcAft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Victims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6480" marR="96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7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9. Security officers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98" name="" descr=""/>
          <p:cNvPicPr/>
          <p:nvPr/>
        </p:nvPicPr>
        <p:blipFill>
          <a:blip r:embed="rId1"/>
          <a:stretch/>
        </p:blipFill>
        <p:spPr>
          <a:xfrm>
            <a:off x="514080" y="1600200"/>
            <a:ext cx="9258120" cy="4525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0" name="Group 2"/>
          <p:cNvGrpSpPr/>
          <p:nvPr/>
        </p:nvGrpSpPr>
        <p:grpSpPr>
          <a:xfrm>
            <a:off x="936720" y="406440"/>
            <a:ext cx="6536880" cy="6451560"/>
            <a:chOff x="936720" y="406440"/>
            <a:chExt cx="6536880" cy="6451560"/>
          </a:xfrm>
        </p:grpSpPr>
        <p:sp>
          <p:nvSpPr>
            <p:cNvPr id="101" name="Rectangle 375"/>
            <p:cNvSpPr/>
            <p:nvPr/>
          </p:nvSpPr>
          <p:spPr>
            <a:xfrm>
              <a:off x="1212840" y="412560"/>
              <a:ext cx="1682280" cy="981000"/>
            </a:xfrm>
            <a:prstGeom prst="rect">
              <a:avLst/>
            </a:prstGeom>
            <a:solidFill>
              <a:srgbClr val="5b9bd5"/>
            </a:solidFill>
            <a:ln w="1260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Individual or group level awareness programmes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Rectangle 373"/>
            <p:cNvSpPr/>
            <p:nvPr/>
          </p:nvSpPr>
          <p:spPr>
            <a:xfrm>
              <a:off x="5245200" y="406440"/>
              <a:ext cx="1823400" cy="993600"/>
            </a:xfrm>
            <a:prstGeom prst="rect">
              <a:avLst/>
            </a:prstGeom>
            <a:solidFill>
              <a:srgbClr val="5b9bd5"/>
            </a:solidFill>
            <a:ln w="1260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>
                <a:lnSpc>
                  <a:spcPct val="100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Restrict availability (10 groups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Rectangle 397"/>
            <p:cNvSpPr/>
            <p:nvPr/>
          </p:nvSpPr>
          <p:spPr>
            <a:xfrm>
              <a:off x="968760" y="1666800"/>
              <a:ext cx="1720440" cy="1084680"/>
            </a:xfrm>
            <a:prstGeom prst="rect">
              <a:avLst/>
            </a:prstGeom>
            <a:solidFill>
              <a:srgbClr val="5b9bd5"/>
            </a:solidFill>
            <a:ln w="1260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just">
                <a:lnSpc>
                  <a:spcPct val="100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Use victims to deliver message to others – 9 groups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 algn="just">
                <a:lnSpc>
                  <a:spcPct val="100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Rectangle 396"/>
            <p:cNvSpPr/>
            <p:nvPr/>
          </p:nvSpPr>
          <p:spPr>
            <a:xfrm>
              <a:off x="5566320" y="1666800"/>
              <a:ext cx="1900800" cy="1117440"/>
            </a:xfrm>
            <a:prstGeom prst="rect">
              <a:avLst/>
            </a:prstGeom>
            <a:solidFill>
              <a:srgbClr val="5b9bd5"/>
            </a:solidFill>
            <a:ln w="1260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lvl="1" marL="457200" algn="just">
                <a:lnSpc>
                  <a:spcPct val="100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1" lang="en-GB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TV Ads – 3 groups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376"/>
            <p:cNvSpPr/>
            <p:nvPr/>
          </p:nvSpPr>
          <p:spPr>
            <a:xfrm>
              <a:off x="936720" y="2907000"/>
              <a:ext cx="1707120" cy="1000800"/>
            </a:xfrm>
            <a:prstGeom prst="rect">
              <a:avLst/>
            </a:prstGeom>
            <a:solidFill>
              <a:srgbClr val="5b9bd5"/>
            </a:solidFill>
            <a:ln w="1260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Use religious leader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Rectangle 395"/>
            <p:cNvSpPr/>
            <p:nvPr/>
          </p:nvSpPr>
          <p:spPr>
            <a:xfrm>
              <a:off x="5579280" y="2887920"/>
              <a:ext cx="1894320" cy="1104480"/>
            </a:xfrm>
            <a:prstGeom prst="rect">
              <a:avLst/>
            </a:prstGeom>
            <a:solidFill>
              <a:srgbClr val="5b9bd5"/>
            </a:solidFill>
            <a:ln w="1260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lvl="1" marL="457200" algn="just">
                <a:lnSpc>
                  <a:spcPct val="100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Newspaper Ads – 2 groups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Rectangle 394"/>
            <p:cNvSpPr/>
            <p:nvPr/>
          </p:nvSpPr>
          <p:spPr>
            <a:xfrm>
              <a:off x="975240" y="4109760"/>
              <a:ext cx="1721160" cy="961560"/>
            </a:xfrm>
            <a:prstGeom prst="rect">
              <a:avLst/>
            </a:prstGeom>
            <a:solidFill>
              <a:srgbClr val="5b9bd5"/>
            </a:solidFill>
            <a:ln w="1260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>
                <a:lnSpc>
                  <a:spcPct val="100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1" lang="en-GB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Billboards &amp; Posters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Rectangle 393"/>
            <p:cNvSpPr/>
            <p:nvPr/>
          </p:nvSpPr>
          <p:spPr>
            <a:xfrm>
              <a:off x="5585760" y="4122720"/>
              <a:ext cx="1887480" cy="994320"/>
            </a:xfrm>
            <a:prstGeom prst="rect">
              <a:avLst/>
            </a:prstGeom>
            <a:solidFill>
              <a:srgbClr val="5b9bd5"/>
            </a:solidFill>
            <a:ln w="1260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>
                <a:lnSpc>
                  <a:spcPct val="100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Short video and continuous reminding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Rectangle 392"/>
            <p:cNvSpPr/>
            <p:nvPr/>
          </p:nvSpPr>
          <p:spPr>
            <a:xfrm>
              <a:off x="981360" y="5220720"/>
              <a:ext cx="1727280" cy="1305720"/>
            </a:xfrm>
            <a:prstGeom prst="rect">
              <a:avLst/>
            </a:prstGeom>
            <a:solidFill>
              <a:srgbClr val="5b9bd5"/>
            </a:solidFill>
            <a:ln w="1260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News papers only 4 groups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Rectangle 391"/>
            <p:cNvSpPr/>
            <p:nvPr/>
          </p:nvSpPr>
          <p:spPr>
            <a:xfrm>
              <a:off x="5604840" y="5311800"/>
              <a:ext cx="1867680" cy="935280"/>
            </a:xfrm>
            <a:prstGeom prst="rect">
              <a:avLst/>
            </a:prstGeom>
            <a:solidFill>
              <a:srgbClr val="5b9bd5"/>
            </a:solidFill>
            <a:ln w="1260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lvl="1" marL="457200" algn="just">
                <a:lnSpc>
                  <a:spcPct val="100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Use public transport and paste stickers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Rectangle 390"/>
            <p:cNvSpPr/>
            <p:nvPr/>
          </p:nvSpPr>
          <p:spPr>
            <a:xfrm>
              <a:off x="2856600" y="5994360"/>
              <a:ext cx="2631960" cy="863640"/>
            </a:xfrm>
            <a:prstGeom prst="rect">
              <a:avLst/>
            </a:prstGeom>
            <a:solidFill>
              <a:srgbClr val="5b9bd5"/>
            </a:solidFill>
            <a:ln w="1260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>
                <a:lnSpc>
                  <a:spcPct val="100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Enforce regulations/ fine in work places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Oval 389"/>
            <p:cNvSpPr/>
            <p:nvPr/>
          </p:nvSpPr>
          <p:spPr>
            <a:xfrm>
              <a:off x="3235320" y="2154240"/>
              <a:ext cx="1816920" cy="3359160"/>
            </a:xfrm>
            <a:prstGeom prst="ellipse">
              <a:avLst/>
            </a:prstGeom>
            <a:solidFill>
              <a:srgbClr val="5b9bd5"/>
            </a:solidFill>
            <a:ln w="12600">
              <a:solidFill>
                <a:srgbClr val="41719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Control methods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13" name="Straight Arrow Connector 388"/>
            <p:cNvCxnSpPr/>
            <p:nvPr/>
          </p:nvCxnSpPr>
          <p:spPr>
            <a:xfrm flipV="1">
              <a:off x="4140360" y="1457640"/>
              <a:ext cx="1080" cy="676440"/>
            </a:xfrm>
            <a:prstGeom prst="straightConnector1">
              <a:avLst/>
            </a:prstGeom>
            <a:ln w="6480">
              <a:solidFill>
                <a:srgbClr val="5b9bd5"/>
              </a:solidFill>
              <a:miter/>
              <a:tailEnd len="med" type="triangle" w="med"/>
            </a:ln>
          </p:spPr>
        </p:cxnSp>
        <p:cxnSp>
          <p:nvCxnSpPr>
            <p:cNvPr id="114" name="Straight Arrow Connector 387"/>
            <p:cNvCxnSpPr/>
            <p:nvPr/>
          </p:nvCxnSpPr>
          <p:spPr>
            <a:xfrm flipV="1">
              <a:off x="4602600" y="1445040"/>
              <a:ext cx="848520" cy="903960"/>
            </a:xfrm>
            <a:prstGeom prst="straightConnector1">
              <a:avLst/>
            </a:prstGeom>
            <a:ln w="6480">
              <a:solidFill>
                <a:srgbClr val="5b9bd5"/>
              </a:solidFill>
              <a:miter/>
              <a:tailEnd len="med" type="triangle" w="med"/>
            </a:ln>
          </p:spPr>
        </p:cxnSp>
        <p:cxnSp>
          <p:nvCxnSpPr>
            <p:cNvPr id="115" name="Straight Arrow Connector 386"/>
            <p:cNvCxnSpPr/>
            <p:nvPr/>
          </p:nvCxnSpPr>
          <p:spPr>
            <a:xfrm flipH="1" flipV="1">
              <a:off x="2792160" y="1419480"/>
              <a:ext cx="803520" cy="1040400"/>
            </a:xfrm>
            <a:prstGeom prst="straightConnector1">
              <a:avLst/>
            </a:prstGeom>
            <a:ln w="6480">
              <a:solidFill>
                <a:srgbClr val="5b9bd5"/>
              </a:solidFill>
              <a:miter/>
              <a:tailEnd len="med" type="triangle" w="med"/>
            </a:ln>
          </p:spPr>
        </p:cxnSp>
        <p:cxnSp>
          <p:nvCxnSpPr>
            <p:cNvPr id="116" name="Straight Arrow Connector 385"/>
            <p:cNvCxnSpPr/>
            <p:nvPr/>
          </p:nvCxnSpPr>
          <p:spPr>
            <a:xfrm flipH="1" flipV="1">
              <a:off x="2720880" y="2309400"/>
              <a:ext cx="675000" cy="526680"/>
            </a:xfrm>
            <a:prstGeom prst="straightConnector1">
              <a:avLst/>
            </a:prstGeom>
            <a:ln w="6480">
              <a:solidFill>
                <a:srgbClr val="5b9bd5"/>
              </a:solidFill>
              <a:miter/>
              <a:tailEnd len="med" type="triangle" w="med"/>
            </a:ln>
          </p:spPr>
        </p:cxnSp>
        <p:cxnSp>
          <p:nvCxnSpPr>
            <p:cNvPr id="117" name="Straight Arrow Connector 384"/>
            <p:cNvCxnSpPr/>
            <p:nvPr/>
          </p:nvCxnSpPr>
          <p:spPr>
            <a:xfrm flipV="1">
              <a:off x="4974840" y="2334960"/>
              <a:ext cx="559080" cy="728280"/>
            </a:xfrm>
            <a:prstGeom prst="straightConnector1">
              <a:avLst/>
            </a:prstGeom>
            <a:ln w="6480">
              <a:solidFill>
                <a:srgbClr val="5b9bd5"/>
              </a:solidFill>
              <a:miter/>
              <a:tailEnd len="med" type="triangle" w="med"/>
            </a:ln>
          </p:spPr>
        </p:cxnSp>
        <p:cxnSp>
          <p:nvCxnSpPr>
            <p:cNvPr id="118" name="Straight Arrow Connector 383"/>
            <p:cNvCxnSpPr/>
            <p:nvPr/>
          </p:nvCxnSpPr>
          <p:spPr>
            <a:xfrm flipH="1" flipV="1">
              <a:off x="2707920" y="3583440"/>
              <a:ext cx="508320" cy="110880"/>
            </a:xfrm>
            <a:prstGeom prst="straightConnector1">
              <a:avLst/>
            </a:prstGeom>
            <a:ln w="6480">
              <a:solidFill>
                <a:srgbClr val="5b9bd5"/>
              </a:solidFill>
              <a:miter/>
              <a:tailEnd len="med" type="triangle" w="med"/>
            </a:ln>
          </p:spPr>
        </p:cxnSp>
        <p:cxnSp>
          <p:nvCxnSpPr>
            <p:cNvPr id="119" name="Straight Arrow Connector 382"/>
            <p:cNvCxnSpPr/>
            <p:nvPr/>
          </p:nvCxnSpPr>
          <p:spPr>
            <a:xfrm flipV="1">
              <a:off x="5077800" y="3505680"/>
              <a:ext cx="457200" cy="331560"/>
            </a:xfrm>
            <a:prstGeom prst="straightConnector1">
              <a:avLst/>
            </a:prstGeom>
            <a:ln w="6480">
              <a:solidFill>
                <a:srgbClr val="5b9bd5"/>
              </a:solidFill>
              <a:miter/>
              <a:tailEnd len="med" type="triangle" w="med"/>
            </a:ln>
          </p:spPr>
        </p:cxnSp>
        <p:cxnSp>
          <p:nvCxnSpPr>
            <p:cNvPr id="120" name="Straight Arrow Connector 381"/>
            <p:cNvCxnSpPr/>
            <p:nvPr/>
          </p:nvCxnSpPr>
          <p:spPr>
            <a:xfrm flipH="1">
              <a:off x="2714760" y="4499640"/>
              <a:ext cx="572400" cy="72000"/>
            </a:xfrm>
            <a:prstGeom prst="straightConnector1">
              <a:avLst/>
            </a:prstGeom>
            <a:ln w="6480">
              <a:solidFill>
                <a:srgbClr val="5b9bd5"/>
              </a:solidFill>
              <a:miter/>
              <a:tailEnd len="med" type="triangle" w="med"/>
            </a:ln>
          </p:spPr>
        </p:cxnSp>
        <p:cxnSp>
          <p:nvCxnSpPr>
            <p:cNvPr id="121" name="Straight Arrow Connector 380"/>
            <p:cNvCxnSpPr/>
            <p:nvPr/>
          </p:nvCxnSpPr>
          <p:spPr>
            <a:xfrm>
              <a:off x="5013720" y="4480200"/>
              <a:ext cx="545760" cy="279360"/>
            </a:xfrm>
            <a:prstGeom prst="straightConnector1">
              <a:avLst/>
            </a:prstGeom>
            <a:ln w="6480">
              <a:solidFill>
                <a:srgbClr val="5b9bd5"/>
              </a:solidFill>
              <a:miter/>
              <a:tailEnd len="med" type="triangle" w="med"/>
            </a:ln>
          </p:spPr>
        </p:cxnSp>
        <p:cxnSp>
          <p:nvCxnSpPr>
            <p:cNvPr id="122" name="Straight Arrow Connector 379"/>
            <p:cNvCxnSpPr/>
            <p:nvPr/>
          </p:nvCxnSpPr>
          <p:spPr>
            <a:xfrm flipH="1">
              <a:off x="2727720" y="5226840"/>
              <a:ext cx="866880" cy="461880"/>
            </a:xfrm>
            <a:prstGeom prst="straightConnector1">
              <a:avLst/>
            </a:prstGeom>
            <a:ln w="6480">
              <a:solidFill>
                <a:srgbClr val="5b9bd5"/>
              </a:solidFill>
              <a:miter/>
              <a:tailEnd len="med" type="triangle" w="med"/>
            </a:ln>
          </p:spPr>
        </p:cxnSp>
        <p:cxnSp>
          <p:nvCxnSpPr>
            <p:cNvPr id="123" name="Straight Arrow Connector 378"/>
            <p:cNvCxnSpPr/>
            <p:nvPr/>
          </p:nvCxnSpPr>
          <p:spPr>
            <a:xfrm>
              <a:off x="4770360" y="5090400"/>
              <a:ext cx="803520" cy="676440"/>
            </a:xfrm>
            <a:prstGeom prst="straightConnector1">
              <a:avLst/>
            </a:prstGeom>
            <a:ln w="6480">
              <a:solidFill>
                <a:srgbClr val="5b9bd5"/>
              </a:solidFill>
              <a:miter/>
              <a:tailEnd len="med" type="triangle" w="med"/>
            </a:ln>
          </p:spPr>
        </p:cxnSp>
        <p:cxnSp>
          <p:nvCxnSpPr>
            <p:cNvPr id="124" name="Straight Arrow Connector 377"/>
            <p:cNvCxnSpPr/>
            <p:nvPr/>
          </p:nvCxnSpPr>
          <p:spPr>
            <a:xfrm>
              <a:off x="4127760" y="5532480"/>
              <a:ext cx="6840" cy="455400"/>
            </a:xfrm>
            <a:prstGeom prst="straightConnector1">
              <a:avLst/>
            </a:prstGeom>
            <a:ln w="6480">
              <a:solidFill>
                <a:srgbClr val="5b9bd5"/>
              </a:solidFill>
              <a:miter/>
              <a:tailEnd len="med" type="triangle" w="med"/>
            </a:ln>
          </p:spPr>
        </p:cxn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9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Security officers – determinants 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200" name=""/>
          <p:cNvGraphicFramePr/>
          <p:nvPr/>
        </p:nvGraphicFramePr>
        <p:xfrm>
          <a:off x="577800" y="1589040"/>
          <a:ext cx="7201080" cy="2535120"/>
        </p:xfrm>
        <a:graphic>
          <a:graphicData uri="http://schemas.openxmlformats.org/drawingml/2006/table">
            <a:tbl>
              <a:tblPr/>
              <a:tblGrid>
                <a:gridCol w="7201080"/>
              </a:tblGrid>
              <a:tr h="2535120">
                <a:tc>
                  <a:txBody>
                    <a:bodyPr lIns="96480" rIns="96480" tIns="0" bIns="0" anchor="t">
                      <a:noAutofit/>
                    </a:bodyPr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 reduce sleepines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 reduce tirednes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 reduce lonelines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njoy chewing reflex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 relax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6480" marR="96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1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Calibri"/>
              </a:rPr>
              <a:t>Security officers - communication methods 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202" name=""/>
          <p:cNvGraphicFramePr/>
          <p:nvPr/>
        </p:nvGraphicFramePr>
        <p:xfrm>
          <a:off x="577800" y="1432080"/>
          <a:ext cx="6491160" cy="2462040"/>
        </p:xfrm>
        <a:graphic>
          <a:graphicData uri="http://schemas.openxmlformats.org/drawingml/2006/table">
            <a:tbl>
              <a:tblPr/>
              <a:tblGrid>
                <a:gridCol w="6491160"/>
              </a:tblGrid>
              <a:tr h="2462040">
                <a:tc>
                  <a:txBody>
                    <a:bodyPr lIns="57960" rIns="57960" tIns="0" bIns="0" anchor="t">
                      <a:noAutofit/>
                    </a:bodyPr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ffffff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28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Literate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ffffff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28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Read newspaper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ffffff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28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Use phones for Calls Only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ffffff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28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Radio – night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ffffff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28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TV (Hiru, Derana) night only - new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>
                        <a:lnSpc>
                          <a:spcPct val="107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960" marR="579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3" name="PlaceHolder 1"/>
          <p:cNvSpPr>
            <a:spLocks noGrp="1"/>
          </p:cNvSpPr>
          <p:nvPr>
            <p:ph type="title"/>
          </p:nvPr>
        </p:nvSpPr>
        <p:spPr>
          <a:xfrm>
            <a:off x="577440" y="4487400"/>
            <a:ext cx="7908840" cy="15066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Security officers - control methods 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204" name=""/>
          <p:cNvGraphicFramePr/>
          <p:nvPr/>
        </p:nvGraphicFramePr>
        <p:xfrm>
          <a:off x="577800" y="2135160"/>
          <a:ext cx="7201080" cy="2282760"/>
        </p:xfrm>
        <a:graphic>
          <a:graphicData uri="http://schemas.openxmlformats.org/drawingml/2006/table">
            <a:tbl>
              <a:tblPr/>
              <a:tblGrid>
                <a:gridCol w="7201080"/>
              </a:tblGrid>
              <a:tr h="2282760">
                <a:tc>
                  <a:txBody>
                    <a:bodyPr lIns="96480" rIns="96480" tIns="0" bIns="0" anchor="t">
                      <a:noAutofit/>
                    </a:bodyPr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orkplace health education &amp; promotion activitie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adio programmes at night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ewspaper advertisements 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spcAft>
                          <a:spcPts val="799"/>
                        </a:spcAft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dvice through religious leader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6480" marR="96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10. Farmers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06" name="" descr=""/>
          <p:cNvPicPr/>
          <p:nvPr/>
        </p:nvPicPr>
        <p:blipFill>
          <a:blip r:embed="rId1"/>
          <a:stretch/>
        </p:blipFill>
        <p:spPr>
          <a:xfrm>
            <a:off x="514080" y="1600200"/>
            <a:ext cx="9258120" cy="4525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7" name="PlaceHolder 1"/>
          <p:cNvSpPr>
            <a:spLocks noGrp="1"/>
          </p:cNvSpPr>
          <p:nvPr>
            <p:ph type="title"/>
          </p:nvPr>
        </p:nvSpPr>
        <p:spPr>
          <a:xfrm>
            <a:off x="693360" y="5351040"/>
            <a:ext cx="7201080" cy="15066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Farmers - determinants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208" name=""/>
          <p:cNvGraphicFramePr/>
          <p:nvPr/>
        </p:nvGraphicFramePr>
        <p:xfrm>
          <a:off x="615960" y="328680"/>
          <a:ext cx="8945640" cy="5022720"/>
        </p:xfrm>
        <a:graphic>
          <a:graphicData uri="http://schemas.openxmlformats.org/drawingml/2006/table">
            <a:tbl>
              <a:tblPr/>
              <a:tblGrid>
                <a:gridCol w="8945640"/>
              </a:tblGrid>
              <a:tr h="5022720">
                <a:tc>
                  <a:txBody>
                    <a:bodyPr lIns="96480" rIns="96480" tIns="0" bIns="0" anchor="t">
                      <a:noAutofit/>
                    </a:bodyPr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 get energized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et &amp; cold feeling – to feel warm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 prevent attacks by water leache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 be in company with other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duced by other chewer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etel and areca nut are available at home garden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onelines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njoy reflex of Chewing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 delay main meals – chew after tea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hen observe sil – betel offered with lunch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 prevent bad breath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6480" marR="96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9" name="PlaceHolder 1"/>
          <p:cNvSpPr>
            <a:spLocks noGrp="1"/>
          </p:cNvSpPr>
          <p:nvPr>
            <p:ph type="title"/>
          </p:nvPr>
        </p:nvSpPr>
        <p:spPr>
          <a:xfrm>
            <a:off x="577800" y="4487400"/>
            <a:ext cx="8586720" cy="15066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Farmers - communication methods 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210" name=""/>
          <p:cNvGraphicFramePr/>
          <p:nvPr/>
        </p:nvGraphicFramePr>
        <p:xfrm>
          <a:off x="646200" y="933480"/>
          <a:ext cx="7162560" cy="3619440"/>
        </p:xfrm>
        <a:graphic>
          <a:graphicData uri="http://schemas.openxmlformats.org/drawingml/2006/table">
            <a:tbl>
              <a:tblPr/>
              <a:tblGrid>
                <a:gridCol w="7162560"/>
              </a:tblGrid>
              <a:tr h="3649320">
                <a:tc>
                  <a:txBody>
                    <a:bodyPr lIns="96480" rIns="96480" tIns="0" bIns="0" anchor="t">
                      <a:noAutofit/>
                    </a:bodyPr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artially literate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ead newspapers - Sunday Lankadeepa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osters of no use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atch TV (Derana, Hiru, Swarnawahini) Lunch-time news &amp; evening  news / night time tele drama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ardly listen to radio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6480" marR="96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1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Farmers – control methods 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212" name=""/>
          <p:cNvGraphicFramePr/>
          <p:nvPr/>
        </p:nvGraphicFramePr>
        <p:xfrm>
          <a:off x="546120" y="1308240"/>
          <a:ext cx="7200720" cy="3162240"/>
        </p:xfrm>
        <a:graphic>
          <a:graphicData uri="http://schemas.openxmlformats.org/drawingml/2006/table">
            <a:tbl>
              <a:tblPr/>
              <a:tblGrid>
                <a:gridCol w="7200720"/>
              </a:tblGrid>
              <a:tr h="3193200">
                <a:tc>
                  <a:txBody>
                    <a:bodyPr lIns="96480" rIns="96480" tIns="0" bIns="0" anchor="t">
                      <a:noAutofit/>
                    </a:bodyPr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V Advertisements – short ones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05 – 15 Seconds) – longer ones of no use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dvertisements in-between tele drama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se of victims to educate on risk factor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ddressing this topic in public meeting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spcAft>
                          <a:spcPts val="799"/>
                        </a:spcAft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isplay posters in market area (“Kada Pila”)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6480" marR="96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3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11. Clerks  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14" name="" descr=""/>
          <p:cNvPicPr/>
          <p:nvPr/>
        </p:nvPicPr>
        <p:blipFill>
          <a:blip r:embed="rId1"/>
          <a:stretch/>
        </p:blipFill>
        <p:spPr>
          <a:xfrm>
            <a:off x="514080" y="1600200"/>
            <a:ext cx="9258120" cy="4525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erks – determinants 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216" name=""/>
          <p:cNvGraphicFramePr/>
          <p:nvPr/>
        </p:nvGraphicFramePr>
        <p:xfrm>
          <a:off x="739800" y="1174680"/>
          <a:ext cx="7318440" cy="2911680"/>
        </p:xfrm>
        <a:graphic>
          <a:graphicData uri="http://schemas.openxmlformats.org/drawingml/2006/table">
            <a:tbl>
              <a:tblPr/>
              <a:tblGrid>
                <a:gridCol w="7318440"/>
              </a:tblGrid>
              <a:tr h="2916000">
                <a:tc>
                  <a:txBody>
                    <a:bodyPr lIns="57960" rIns="57960" tIns="0" bIns="0" anchor="t">
                      <a:noAutofit/>
                    </a:bodyPr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ffffff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8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To quit Smoking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ffffff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8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This is part of the main meal (after lunch, dinner)  and even after Tea.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ffffff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8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To reduce unpleasant taste in the mouth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ffffff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8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Sleepiness, Laziness, Lonelines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ffffff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8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Family Background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960" marR="579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7" name="PlaceHolder 1"/>
          <p:cNvSpPr>
            <a:spLocks noGrp="1"/>
          </p:cNvSpPr>
          <p:nvPr>
            <p:ph type="title"/>
          </p:nvPr>
        </p:nvSpPr>
        <p:spPr>
          <a:xfrm>
            <a:off x="577440" y="4487400"/>
            <a:ext cx="7854840" cy="15066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erks - communication methods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218" name=""/>
          <p:cNvGraphicFramePr/>
          <p:nvPr/>
        </p:nvGraphicFramePr>
        <p:xfrm>
          <a:off x="905040" y="1170000"/>
          <a:ext cx="7200720" cy="2414520"/>
        </p:xfrm>
        <a:graphic>
          <a:graphicData uri="http://schemas.openxmlformats.org/drawingml/2006/table">
            <a:tbl>
              <a:tblPr/>
              <a:tblGrid>
                <a:gridCol w="7200720"/>
              </a:tblGrid>
              <a:tr h="2414520">
                <a:tc>
                  <a:txBody>
                    <a:bodyPr lIns="96480" rIns="96480" tIns="0" bIns="0" anchor="t">
                      <a:noAutofit/>
                    </a:bodyPr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iterate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ead newspapers daily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atch TV (Derana, Hiru) – mainly new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o not listen to radio much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se telephone only for call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6480" marR="96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5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  <a:ea typeface="Arial"/>
              </a:rPr>
              <a:t>To fulfil SO1 and to initiate activities related to SO2 and SO3 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"/>
          <p:cNvSpPr txBox="1"/>
          <p:nvPr/>
        </p:nvSpPr>
        <p:spPr>
          <a:xfrm>
            <a:off x="514080" y="1600200"/>
            <a:ext cx="925812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lnSpc>
                <a:spcPct val="100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  <a:ea typeface="Arial"/>
              </a:rPr>
              <a:t>Determinants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  <a:ea typeface="Arial"/>
              </a:rPr>
              <a:t>Communication methods  used by / proposed by participants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  <a:ea typeface="Arial"/>
              </a:rPr>
              <a:t>Control methods proposed by participants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100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9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erks – control methods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220" name=""/>
          <p:cNvGraphicFramePr/>
          <p:nvPr/>
        </p:nvGraphicFramePr>
        <p:xfrm>
          <a:off x="538200" y="1324080"/>
          <a:ext cx="7200720" cy="3652560"/>
        </p:xfrm>
        <a:graphic>
          <a:graphicData uri="http://schemas.openxmlformats.org/drawingml/2006/table">
            <a:tbl>
              <a:tblPr/>
              <a:tblGrid>
                <a:gridCol w="7200720"/>
              </a:tblGrid>
              <a:tr h="3652560">
                <a:tc>
                  <a:txBody>
                    <a:bodyPr lIns="96480" rIns="96480" tIns="0" bIns="0" anchor="t">
                      <a:noAutofit/>
                    </a:bodyPr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ewspaper Advertisement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orkplace health education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dvise through religious Leaders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se victim groups – best method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dvice by doctors of no use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eaflets of no use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lay educational videos in TV displays at office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6480" marR="96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1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12. Self Employed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22" name="" descr=""/>
          <p:cNvPicPr/>
          <p:nvPr/>
        </p:nvPicPr>
        <p:blipFill>
          <a:blip r:embed="rId1"/>
          <a:stretch/>
        </p:blipFill>
        <p:spPr>
          <a:xfrm>
            <a:off x="514080" y="1600200"/>
            <a:ext cx="9258120" cy="4525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3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Self Employed - determinants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224" name=""/>
          <p:cNvGraphicFramePr/>
          <p:nvPr/>
        </p:nvGraphicFramePr>
        <p:xfrm>
          <a:off x="577800" y="2224080"/>
          <a:ext cx="7201080" cy="1384200"/>
        </p:xfrm>
        <a:graphic>
          <a:graphicData uri="http://schemas.openxmlformats.org/drawingml/2006/table">
            <a:tbl>
              <a:tblPr/>
              <a:tblGrid>
                <a:gridCol w="7201080"/>
              </a:tblGrid>
              <a:tr h="1417320">
                <a:tc>
                  <a:txBody>
                    <a:bodyPr lIns="96480" rIns="96480" tIns="0" bIns="0" anchor="t">
                      <a:noAutofit/>
                    </a:bodyPr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npleasant feeling in the Mouth</a:t>
                      </a:r>
                      <a:endParaRPr b="0" lang="en-US" sz="2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leepiness</a:t>
                      </a:r>
                      <a:endParaRPr b="0" lang="en-US" sz="2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spcAft>
                          <a:spcPts val="799"/>
                        </a:spcAft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 maintain company with others </a:t>
                      </a:r>
                      <a:endParaRPr b="0" lang="en-US" sz="2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6480" marR="96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" name="PlaceHolder 1"/>
          <p:cNvSpPr>
            <a:spLocks noGrp="1"/>
          </p:cNvSpPr>
          <p:nvPr>
            <p:ph type="title"/>
          </p:nvPr>
        </p:nvSpPr>
        <p:spPr>
          <a:xfrm>
            <a:off x="577440" y="4487400"/>
            <a:ext cx="9132840" cy="15066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Self Employed -  communication methods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226" name=""/>
          <p:cNvGraphicFramePr/>
          <p:nvPr/>
        </p:nvGraphicFramePr>
        <p:xfrm>
          <a:off x="577800" y="1405080"/>
          <a:ext cx="7201080" cy="3162240"/>
        </p:xfrm>
        <a:graphic>
          <a:graphicData uri="http://schemas.openxmlformats.org/drawingml/2006/table">
            <a:tbl>
              <a:tblPr/>
              <a:tblGrid>
                <a:gridCol w="7201080"/>
              </a:tblGrid>
              <a:tr h="3193200">
                <a:tc>
                  <a:txBody>
                    <a:bodyPr lIns="96480" rIns="96480" tIns="0" bIns="0" anchor="t">
                      <a:noAutofit/>
                    </a:bodyPr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iterate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ead newspapers at boutique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ersonnel communications at the boutique with regards to health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ealth messages communicated by the hospital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V (Hiru, Derana)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6480" marR="96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7" name="PlaceHolder 1"/>
          <p:cNvSpPr>
            <a:spLocks noGrp="1"/>
          </p:cNvSpPr>
          <p:nvPr>
            <p:ph type="title"/>
          </p:nvPr>
        </p:nvSpPr>
        <p:spPr>
          <a:xfrm>
            <a:off x="577440" y="4487400"/>
            <a:ext cx="7643880" cy="15066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Self Employed -  control methods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228" name=""/>
          <p:cNvGraphicFramePr/>
          <p:nvPr/>
        </p:nvGraphicFramePr>
        <p:xfrm>
          <a:off x="577800" y="2313000"/>
          <a:ext cx="7201080" cy="1384200"/>
        </p:xfrm>
        <a:graphic>
          <a:graphicData uri="http://schemas.openxmlformats.org/drawingml/2006/table">
            <a:tbl>
              <a:tblPr/>
              <a:tblGrid>
                <a:gridCol w="7201080"/>
              </a:tblGrid>
              <a:tr h="1417320">
                <a:tc>
                  <a:txBody>
                    <a:bodyPr lIns="96480" rIns="96480" tIns="0" bIns="0" anchor="t">
                      <a:noAutofit/>
                    </a:bodyPr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crease awareness on law related to ST</a:t>
                      </a:r>
                      <a:endParaRPr b="0" lang="en-US" sz="2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dvice through religious leaders </a:t>
                      </a:r>
                      <a:endParaRPr b="0" lang="en-US" sz="2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6480" marR="96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9" name="PlaceHolder 1"/>
          <p:cNvSpPr>
            <a:spLocks noGrp="1"/>
          </p:cNvSpPr>
          <p:nvPr>
            <p:ph type="title"/>
          </p:nvPr>
        </p:nvSpPr>
        <p:spPr>
          <a:xfrm>
            <a:off x="577440" y="4487400"/>
            <a:ext cx="7512120" cy="15066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13. Tamil community - housewives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30" name="Picture 2" descr="Image result for kovil"/>
          <p:cNvPicPr/>
          <p:nvPr/>
        </p:nvPicPr>
        <p:blipFill>
          <a:blip r:embed="rId1"/>
          <a:stretch/>
        </p:blipFill>
        <p:spPr>
          <a:xfrm>
            <a:off x="736560" y="873000"/>
            <a:ext cx="4575240" cy="3614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1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Tamil Housewives – Determinants 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232" name=""/>
          <p:cNvGraphicFramePr/>
          <p:nvPr/>
        </p:nvGraphicFramePr>
        <p:xfrm>
          <a:off x="577800" y="2313000"/>
          <a:ext cx="7201080" cy="914400"/>
        </p:xfrm>
        <a:graphic>
          <a:graphicData uri="http://schemas.openxmlformats.org/drawingml/2006/table">
            <a:tbl>
              <a:tblPr/>
              <a:tblGrid>
                <a:gridCol w="7201080"/>
              </a:tblGrid>
              <a:tr h="945000">
                <a:tc>
                  <a:txBody>
                    <a:bodyPr lIns="96480" rIns="96480" tIns="0" bIns="0" anchor="t">
                      <a:noAutofit/>
                    </a:bodyPr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 engage in work – get energized</a:t>
                      </a:r>
                      <a:endParaRPr b="0" lang="en-US" sz="2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spcAft>
                          <a:spcPts val="799"/>
                        </a:spcAft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ike – desire </a:t>
                      </a:r>
                      <a:endParaRPr b="0" lang="en-US" sz="2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6480" marR="96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3" name="PlaceHolder 1"/>
          <p:cNvSpPr>
            <a:spLocks noGrp="1"/>
          </p:cNvSpPr>
          <p:nvPr>
            <p:ph type="title"/>
          </p:nvPr>
        </p:nvSpPr>
        <p:spPr>
          <a:xfrm>
            <a:off x="577800" y="4487400"/>
            <a:ext cx="9522000" cy="15066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Tamil Housewives - communication methods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234" name=""/>
          <p:cNvGraphicFramePr/>
          <p:nvPr/>
        </p:nvGraphicFramePr>
        <p:xfrm>
          <a:off x="515880" y="511200"/>
          <a:ext cx="7201080" cy="5022720"/>
        </p:xfrm>
        <a:graphic>
          <a:graphicData uri="http://schemas.openxmlformats.org/drawingml/2006/table">
            <a:tbl>
              <a:tblPr/>
              <a:tblGrid>
                <a:gridCol w="7201080"/>
              </a:tblGrid>
              <a:tr h="5022720">
                <a:tc>
                  <a:txBody>
                    <a:bodyPr lIns="96480" rIns="96480" tIns="0" bIns="0" anchor="t">
                      <a:noAutofit/>
                    </a:bodyPr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lliterate / partially literate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se phone – only for call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o not read newspaper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 radio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et information from hospitals re – health issue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atch TV (Shakthi - 10-12 Morning / 6-10 evening). No advertisements on ST in Shakthi TV - Advertisements useful during this time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6480" marR="96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" name="PlaceHolder 1"/>
          <p:cNvSpPr>
            <a:spLocks noGrp="1"/>
          </p:cNvSpPr>
          <p:nvPr>
            <p:ph type="title"/>
          </p:nvPr>
        </p:nvSpPr>
        <p:spPr>
          <a:xfrm>
            <a:off x="577440" y="4487400"/>
            <a:ext cx="8688600" cy="15066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Tamil Housewives – control methods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236" name=""/>
          <p:cNvGraphicFramePr/>
          <p:nvPr/>
        </p:nvGraphicFramePr>
        <p:xfrm>
          <a:off x="577800" y="2224080"/>
          <a:ext cx="7201080" cy="1857240"/>
        </p:xfrm>
        <a:graphic>
          <a:graphicData uri="http://schemas.openxmlformats.org/drawingml/2006/table">
            <a:tbl>
              <a:tblPr/>
              <a:tblGrid>
                <a:gridCol w="7201080"/>
              </a:tblGrid>
              <a:tr h="1889640">
                <a:tc>
                  <a:txBody>
                    <a:bodyPr lIns="96480" rIns="96480" tIns="0" bIns="0" anchor="t">
                      <a:noAutofit/>
                    </a:bodyPr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V ads in Shakthi TV</a:t>
                      </a:r>
                      <a:endParaRPr b="0" lang="en-US" sz="2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ducate ‘Swami’ in Kovil (People respect swami’s advice)</a:t>
                      </a:r>
                      <a:endParaRPr b="0" lang="en-US" sz="2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et Swami to advice people</a:t>
                      </a:r>
                      <a:endParaRPr b="0" lang="en-US" sz="2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6480" marR="96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7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14. Muslim community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38" name="Picture 2" descr="Image result for mosque sri lanka"/>
          <p:cNvPicPr/>
          <p:nvPr/>
        </p:nvPicPr>
        <p:blipFill>
          <a:blip r:embed="rId1"/>
          <a:stretch/>
        </p:blipFill>
        <p:spPr>
          <a:xfrm>
            <a:off x="2236680" y="2467080"/>
            <a:ext cx="3579840" cy="3867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28" name=""/>
          <p:cNvGraphicFramePr/>
          <p:nvPr/>
        </p:nvGraphicFramePr>
        <p:xfrm>
          <a:off x="811080" y="204840"/>
          <a:ext cx="8541000" cy="6784920"/>
        </p:xfrm>
        <a:graphic>
          <a:graphicData uri="http://schemas.openxmlformats.org/drawingml/2006/table">
            <a:tbl>
              <a:tblPr/>
              <a:tblGrid>
                <a:gridCol w="2671920"/>
                <a:gridCol w="2498760"/>
                <a:gridCol w="1741320"/>
                <a:gridCol w="1629000"/>
              </a:tblGrid>
              <a:tr h="625320">
                <a:tc>
                  <a:txBody>
                    <a:bodyPr lIns="77040" rIns="770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7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Group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7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Area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7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In-depth interviews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7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FGDs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</a:tr>
              <a:tr h="480960">
                <a:tc>
                  <a:txBody>
                    <a:bodyPr lIns="77040" rIns="7704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 Fishing community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ilaw 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7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1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358920">
                <a:tc>
                  <a:txBody>
                    <a:bodyPr lIns="77040" rIns="7704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 Estate workers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atnapura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6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1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357120">
                <a:tc>
                  <a:txBody>
                    <a:bodyPr lIns="77040" rIns="7704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 Gem mine workers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lapaha, Ratnapura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5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1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490680">
                <a:tc>
                  <a:txBody>
                    <a:bodyPr lIns="77040" rIns="7704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 Three wheeler drivers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ugegoda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5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1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357120">
                <a:tc>
                  <a:txBody>
                    <a:bodyPr lIns="77040" rIns="7704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. Urban youth 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C area, Chilaw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7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1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625320">
                <a:tc>
                  <a:txBody>
                    <a:bodyPr lIns="77040" rIns="7704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. Construction site workers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awala Road, Nugegoda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5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1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357480">
                <a:tc>
                  <a:txBody>
                    <a:bodyPr lIns="77040" rIns="7704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. MC Labourers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C, Kurunegala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4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2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625320">
                <a:tc>
                  <a:txBody>
                    <a:bodyPr lIns="77040" rIns="7704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. Bus drivers &amp; conductors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ugegoda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5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1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357120">
                <a:tc>
                  <a:txBody>
                    <a:bodyPr lIns="77040" rIns="7704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. Security officers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urugegala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4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358920">
                <a:tc>
                  <a:txBody>
                    <a:bodyPr lIns="77040" rIns="7704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. Farmers 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uwanwella, Kegalle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3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1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358560">
                <a:tc>
                  <a:txBody>
                    <a:bodyPr lIns="77040" rIns="7704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1. Clerks 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urunegala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3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357480">
                <a:tc>
                  <a:txBody>
                    <a:bodyPr lIns="77040" rIns="7704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2. Self-employed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uwanwella, Kegalle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2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358560">
                <a:tc>
                  <a:txBody>
                    <a:bodyPr lIns="77040" rIns="7704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3. Tamil community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ousewives - Chilaw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1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357120">
                <a:tc>
                  <a:txBody>
                    <a:bodyPr lIns="77040" rIns="7704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4. Muslim community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uwanwella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5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358920">
                <a:tc>
                  <a:txBody>
                    <a:bodyPr lIns="77040" rIns="7704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TAL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2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77040" rIns="7704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</a:t>
                      </a:r>
                      <a:endParaRPr b="0" lang="en-US" sz="1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7040" marR="77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9" name="PlaceHolder 1"/>
          <p:cNvSpPr>
            <a:spLocks noGrp="1"/>
          </p:cNvSpPr>
          <p:nvPr>
            <p:ph type="title"/>
          </p:nvPr>
        </p:nvSpPr>
        <p:spPr>
          <a:xfrm>
            <a:off x="577800" y="4487400"/>
            <a:ext cx="8656560" cy="15066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Muslim community – Determinants 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240" name=""/>
          <p:cNvGraphicFramePr/>
          <p:nvPr/>
        </p:nvGraphicFramePr>
        <p:xfrm>
          <a:off x="577800" y="2468520"/>
          <a:ext cx="7201080" cy="455760"/>
        </p:xfrm>
        <a:graphic>
          <a:graphicData uri="http://schemas.openxmlformats.org/drawingml/2006/table">
            <a:tbl>
              <a:tblPr/>
              <a:tblGrid>
                <a:gridCol w="7201080"/>
              </a:tblGrid>
              <a:tr h="488880">
                <a:tc>
                  <a:txBody>
                    <a:bodyPr lIns="96480" rIns="96480" tIns="0" bIns="0" anchor="t">
                      <a:noAutofit/>
                    </a:bodyPr>
                    <a:p>
                      <a:pPr marL="343080" indent="-343080" algn="just">
                        <a:lnSpc>
                          <a:spcPct val="107000"/>
                        </a:lnSpc>
                        <a:spcAft>
                          <a:spcPts val="799"/>
                        </a:spcAft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leepiness</a:t>
                      </a:r>
                      <a:endParaRPr b="0" lang="en-US" sz="3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6480" marR="96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1" name="PlaceHolder 1"/>
          <p:cNvSpPr>
            <a:spLocks noGrp="1"/>
          </p:cNvSpPr>
          <p:nvPr>
            <p:ph type="title"/>
          </p:nvPr>
        </p:nvSpPr>
        <p:spPr>
          <a:xfrm>
            <a:off x="577800" y="4487400"/>
            <a:ext cx="9522000" cy="15066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Muslim community - communication methods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242" name=""/>
          <p:cNvGraphicFramePr/>
          <p:nvPr/>
        </p:nvGraphicFramePr>
        <p:xfrm>
          <a:off x="484200" y="1411200"/>
          <a:ext cx="7200720" cy="3195720"/>
        </p:xfrm>
        <a:graphic>
          <a:graphicData uri="http://schemas.openxmlformats.org/drawingml/2006/table">
            <a:tbl>
              <a:tblPr/>
              <a:tblGrid>
                <a:gridCol w="7200720"/>
              </a:tblGrid>
              <a:tr h="3195720">
                <a:tc>
                  <a:txBody>
                    <a:bodyPr lIns="96480" rIns="96480" tIns="0" bIns="0" anchor="t">
                      <a:noAutofit/>
                    </a:bodyPr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artially literate / illiterate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 newspaper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V – (Women watch Derana, Swarnawahini at lunch time and night nime)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adio (Vasantham, Hiru)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spcAft>
                          <a:spcPts val="799"/>
                        </a:spcAft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Young generation use FB, Instagram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6480" marR="96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3" name="PlaceHolder 1"/>
          <p:cNvSpPr>
            <a:spLocks noGrp="1"/>
          </p:cNvSpPr>
          <p:nvPr>
            <p:ph type="title"/>
          </p:nvPr>
        </p:nvSpPr>
        <p:spPr>
          <a:xfrm>
            <a:off x="577440" y="4487400"/>
            <a:ext cx="8688600" cy="15066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Muslim community– control methods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244" name=""/>
          <p:cNvGraphicFramePr/>
          <p:nvPr/>
        </p:nvGraphicFramePr>
        <p:xfrm>
          <a:off x="577800" y="692280"/>
          <a:ext cx="7201080" cy="3652560"/>
        </p:xfrm>
        <a:graphic>
          <a:graphicData uri="http://schemas.openxmlformats.org/drawingml/2006/table">
            <a:tbl>
              <a:tblPr/>
              <a:tblGrid>
                <a:gridCol w="7201080"/>
              </a:tblGrid>
              <a:tr h="3652560">
                <a:tc>
                  <a:txBody>
                    <a:bodyPr lIns="96480" rIns="96480" tIns="0" bIns="0" anchor="t">
                      <a:noAutofit/>
                    </a:bodyPr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wareness programmes after mosque service on Fridays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hrough Welfare Society - mosque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se victims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nforce regulations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hort videos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ontinuous reminding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2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adio is Best for drivers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6480" marR="96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246" name=""/>
          <p:cNvGraphicFramePr/>
          <p:nvPr/>
        </p:nvGraphicFramePr>
        <p:xfrm>
          <a:off x="460440" y="149400"/>
          <a:ext cx="9296280" cy="6692760"/>
        </p:xfrm>
        <a:graphic>
          <a:graphicData uri="http://schemas.openxmlformats.org/drawingml/2006/table">
            <a:tbl>
              <a:tblPr/>
              <a:tblGrid>
                <a:gridCol w="4647960"/>
                <a:gridCol w="4648320"/>
              </a:tblGrid>
              <a:tr h="228240">
                <a:tc>
                  <a:txBody>
                    <a:bodyPr lIns="27720" rIns="27720" tIns="0" bIns="0" anchor="t">
                      <a:noAutofit/>
                    </a:bodyPr>
                    <a:p>
                      <a:pPr algn="ctr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Calibri"/>
                          <a:ea typeface="Calibri"/>
                        </a:rPr>
                        <a:t>Determinant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720" marR="277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27720" rIns="27720" tIns="0" bIns="0" anchor="t">
                      <a:noAutofit/>
                    </a:bodyPr>
                    <a:p>
                      <a:pPr algn="ctr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Calibri"/>
                          <a:ea typeface="Calibri"/>
                        </a:rPr>
                        <a:t>Group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720" marR="277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</a:tr>
              <a:tr h="684000">
                <a:tc>
                  <a:txBody>
                    <a:bodyPr lIns="27720" rIns="2772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00"/>
                          </a:solidFill>
                          <a:latin typeface="Calibri"/>
                          <a:ea typeface="Calibri"/>
                        </a:rPr>
                        <a:t>1. Sleepiness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720" marR="277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27720" rIns="2772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Fishing community, Gem mine workers, Three wheeler drivers, Bus drivers &amp; Conductors, MC labourers, Security officers, Self-employed, Muslim community. </a:t>
                      </a: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(8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720" marR="277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684000">
                <a:tc>
                  <a:txBody>
                    <a:bodyPr lIns="27720" rIns="2772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00"/>
                          </a:solidFill>
                          <a:latin typeface="Calibri"/>
                          <a:ea typeface="Calibri"/>
                        </a:rPr>
                        <a:t>2. Energize / improve efficiency / reduce laziness / reduce tiredness / improve alertness / improve concentration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720" marR="277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27720" rIns="2772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Urban youth, Three wheeler drivers, Construction site workers, Bus drivers &amp; Conductors, MC labourers, Security officers,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Farmers, Tamil housewives </a:t>
                      </a: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(8)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720" marR="277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684000">
                <a:tc>
                  <a:txBody>
                    <a:bodyPr lIns="27720" rIns="2772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00"/>
                          </a:solidFill>
                          <a:latin typeface="Calibri"/>
                          <a:ea typeface="Calibri"/>
                        </a:rPr>
                        <a:t>3. Loneliness 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720" marR="277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27720" rIns="2772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Fishing community,  Gem mine workers, Estate workers, Construction site workers, Bus drivers &amp; Conductors, MC labourers, Clerks, Farmers </a:t>
                      </a: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(8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720" marR="277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456120">
                <a:tc>
                  <a:txBody>
                    <a:bodyPr lIns="27720" rIns="2772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00"/>
                          </a:solidFill>
                          <a:latin typeface="Calibri"/>
                          <a:ea typeface="Calibri"/>
                        </a:rPr>
                        <a:t>4. Peer pressure / Induced by peers / to maintain company with other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720" marR="277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27720" rIns="2772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Urban youth, Estate workers, Gem mine workers,  Construction site workers, farmers, Self-employed </a:t>
                      </a: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(6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720" marR="277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456120">
                <a:tc>
                  <a:txBody>
                    <a:bodyPr lIns="27720" rIns="2772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00"/>
                          </a:solidFill>
                          <a:latin typeface="Calibri"/>
                          <a:ea typeface="Calibri"/>
                        </a:rPr>
                        <a:t>5. Enjoy reflex of chewin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720" marR="277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27720" rIns="2772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Fishing community, Bus drivers &amp; Conductors, MC labourers, Security officers, Farmers </a:t>
                      </a: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(5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720" marR="277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911880">
                <a:tc>
                  <a:txBody>
                    <a:bodyPr lIns="27720" rIns="2772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00"/>
                          </a:solidFill>
                          <a:latin typeface="Calibri"/>
                          <a:ea typeface="Calibri"/>
                        </a:rPr>
                        <a:t>6. To counteract unpleasant smell  / taste / feel freshness in mouth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720" marR="277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27720" rIns="2772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Estate workers (rubber – ottapalu smell), Gem mine workers (mud smell &amp; taste), MC labourers (garbage smell), Clerks (unpleasant taste after meals). </a:t>
                      </a: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(4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 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720" marR="277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257760">
                <a:tc>
                  <a:txBody>
                    <a:bodyPr lIns="27720" rIns="2772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00"/>
                          </a:solidFill>
                          <a:latin typeface="Calibri"/>
                          <a:ea typeface="Calibri"/>
                        </a:rPr>
                        <a:t>7. Wetness / Dampness / cold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720" marR="277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27720" rIns="2772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Fishing community, Estate workers, Gem mine workers (3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720" marR="277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257760">
                <a:tc>
                  <a:txBody>
                    <a:bodyPr lIns="27720" rIns="2772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00"/>
                          </a:solidFill>
                          <a:latin typeface="Calibri"/>
                          <a:ea typeface="Calibri"/>
                        </a:rPr>
                        <a:t>8. Availability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720" marR="277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27720" rIns="2772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Urban youth, Gem mine workers, Farmers (3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720" marR="277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228240">
                <a:tc>
                  <a:txBody>
                    <a:bodyPr lIns="27720" rIns="2772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Calibri"/>
                          <a:ea typeface="Calibri"/>
                        </a:rPr>
                        <a:t>9. To keep away leaches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720" marR="277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27720" rIns="2772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Estate workers, Farmers (2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720" marR="277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228240">
                <a:tc>
                  <a:txBody>
                    <a:bodyPr lIns="27720" rIns="2772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Calibri"/>
                          <a:ea typeface="Calibri"/>
                        </a:rPr>
                        <a:t>10. To break monotony of work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720" marR="277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27720" rIns="2772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Estate workers, Bus drivers &amp; Conductors (2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720" marR="277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228240">
                <a:tc>
                  <a:txBody>
                    <a:bodyPr lIns="27720" rIns="2772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Calibri"/>
                          <a:ea typeface="Calibri"/>
                        </a:rPr>
                        <a:t>11. Don’t feel hungry / to delay meal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720" marR="277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27720" rIns="2772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Bus drivers &amp; Conductors, farmers (2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720" marR="277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228240">
                <a:tc>
                  <a:txBody>
                    <a:bodyPr lIns="27720" rIns="27720" tIns="0" bIns="0" anchor="t">
                      <a:noAutofit/>
                    </a:bodyPr>
                    <a:p>
                      <a:pPr marL="228600" indent="-228600">
                        <a:lnSpc>
                          <a:spcPct val="107000"/>
                        </a:lnSpc>
                        <a:buClr>
                          <a:srgbClr val="ffffff"/>
                        </a:buClr>
                        <a:buFont typeface="Arial"/>
                        <a:buChar char="•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Calibri"/>
                          <a:ea typeface="Calibri"/>
                        </a:rPr>
                        <a:t>Induce sleep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720" marR="277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27720" rIns="2772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Urban youth (1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720" marR="277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228240">
                <a:tc>
                  <a:txBody>
                    <a:bodyPr lIns="27720" rIns="27720" tIns="0" bIns="0" anchor="t">
                      <a:noAutofit/>
                    </a:bodyPr>
                    <a:p>
                      <a:pPr marL="228600" indent="-228600">
                        <a:lnSpc>
                          <a:spcPct val="107000"/>
                        </a:lnSpc>
                        <a:buClr>
                          <a:srgbClr val="ffffff"/>
                        </a:buClr>
                        <a:buFont typeface="Arial"/>
                        <a:buChar char="•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Calibri"/>
                          <a:ea typeface="Calibri"/>
                        </a:rPr>
                        <a:t>Induce passing stools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720" marR="277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27720" rIns="2772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Estate workers(1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720" marR="277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228240">
                <a:tc>
                  <a:txBody>
                    <a:bodyPr lIns="27720" rIns="27720" tIns="0" bIns="0" anchor="t">
                      <a:noAutofit/>
                    </a:bodyPr>
                    <a:p>
                      <a:pPr marL="228600" indent="-228600">
                        <a:lnSpc>
                          <a:spcPct val="107000"/>
                        </a:lnSpc>
                        <a:buClr>
                          <a:srgbClr val="ffffff"/>
                        </a:buClr>
                        <a:buFont typeface="Arial"/>
                        <a:buChar char="•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Calibri"/>
                          <a:ea typeface="Calibri"/>
                        </a:rPr>
                        <a:t>To relax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720" marR="277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27720" rIns="2772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Security officers(1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720" marR="277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238320">
                <a:tc>
                  <a:txBody>
                    <a:bodyPr lIns="27720" rIns="27720" tIns="0" bIns="0" anchor="t">
                      <a:noAutofit/>
                    </a:bodyPr>
                    <a:p>
                      <a:pPr marL="228600" indent="-228600">
                        <a:lnSpc>
                          <a:spcPct val="107000"/>
                        </a:lnSpc>
                        <a:buClr>
                          <a:srgbClr val="ffffff"/>
                        </a:buClr>
                        <a:buFont typeface="Arial"/>
                        <a:buChar char="•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Calibri"/>
                          <a:ea typeface="Calibri"/>
                        </a:rPr>
                        <a:t>To quit smokin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720" marR="277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27720" rIns="2772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Clerks(1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720" marR="277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235440">
                <a:tc>
                  <a:txBody>
                    <a:bodyPr lIns="27720" rIns="27720" tIns="0" bIns="0" anchor="t">
                      <a:noAutofit/>
                    </a:bodyPr>
                    <a:p>
                      <a:pPr marL="228600" indent="-228600">
                        <a:lnSpc>
                          <a:spcPct val="107000"/>
                        </a:lnSpc>
                        <a:buClr>
                          <a:srgbClr val="ffffff"/>
                        </a:buClr>
                        <a:buFont typeface="Arial"/>
                        <a:buChar char="•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Calibri"/>
                          <a:ea typeface="Calibri"/>
                        </a:rPr>
                        <a:t>No other entertainment / leisure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720" marR="277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27720" rIns="2772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Gem mine workers(1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7720" marR="277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7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ommunication methods 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8" name=""/>
          <p:cNvSpPr txBox="1"/>
          <p:nvPr/>
        </p:nvSpPr>
        <p:spPr>
          <a:xfrm>
            <a:off x="460080" y="2687400"/>
            <a:ext cx="8072280" cy="2192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 fontScale="39000"/>
          </a:bodyPr>
          <a:p>
            <a:pPr marL="133560" indent="-133560">
              <a:lnSpc>
                <a:spcPct val="100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  <a:ea typeface="Arial"/>
              </a:rPr>
              <a:t>Except for urban youth and clerks, other groups are illiterate or partially literate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marL="133560" indent="-133560">
              <a:lnSpc>
                <a:spcPct val="100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  <a:ea typeface="Arial"/>
              </a:rPr>
              <a:t>Except for urban youth, others don’t use smart phones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marL="133560" indent="-133560">
              <a:lnSpc>
                <a:spcPct val="100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  <a:ea typeface="Arial"/>
              </a:rPr>
              <a:t>All groups watch TV at some time of day – most popular channels are Derana (11 groups),Hiru (9 groups), Sirasa (6 groups), Shakthi (4 groups), Swarnawahini (2 groups). None of the groups reported watching state owned TV channels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marL="133560" indent="-133560">
              <a:lnSpc>
                <a:spcPct val="100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  <a:ea typeface="Arial"/>
              </a:rPr>
              <a:t>Only 4 groups reported listening to radio – common channels – Hiru, Neth, Sooriyan, Shakthi, Vasantham, Shaa &amp; Y Fm. All are private channels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marL="133560" indent="-133560">
              <a:lnSpc>
                <a:spcPct val="100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  <a:ea typeface="Arial"/>
              </a:rPr>
              <a:t>Only 4 groups read newpapers at least during the weekend.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marL="133560" indent="-133560">
              <a:lnSpc>
                <a:spcPct val="100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  <a:ea typeface="Arial"/>
              </a:rPr>
              <a:t>Some groups believed that newspapers, leaflets and posters are not effective in delivering messages related to use of smokeless tobacco 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marL="133560" indent="-13356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marL="133560" indent="-13356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marL="133560" indent="-13356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marL="133560" indent="-13356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marL="133560" indent="-13356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9" name="PlaceHolder 1"/>
          <p:cNvSpPr>
            <a:spLocks noGrp="1"/>
          </p:cNvSpPr>
          <p:nvPr>
            <p:ph type="title"/>
          </p:nvPr>
        </p:nvSpPr>
        <p:spPr>
          <a:xfrm>
            <a:off x="577440" y="5143680"/>
            <a:ext cx="7201080" cy="15062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Proposed control methods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0" name=""/>
          <p:cNvSpPr txBox="1"/>
          <p:nvPr/>
        </p:nvSpPr>
        <p:spPr>
          <a:xfrm>
            <a:off x="396720" y="1265040"/>
            <a:ext cx="7972560" cy="3562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 fontScale="62000"/>
          </a:bodyPr>
          <a:p>
            <a:pPr marL="212400" indent="-212400">
              <a:lnSpc>
                <a:spcPct val="100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  <a:ea typeface="Arial"/>
              </a:rPr>
              <a:t>Individual or group level awareness programmes (11 groups) – house to house visit, welfare societies, workplace health education 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marL="212400" indent="-212400">
              <a:lnSpc>
                <a:spcPct val="100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  <a:ea typeface="Arial"/>
              </a:rPr>
              <a:t>Restrict availability (10 groups) – enforce law, impose fines, increase price, block supply chain, workplace regulations, make aware abou law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marL="212400" indent="-212400">
              <a:lnSpc>
                <a:spcPct val="100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  <a:ea typeface="Arial"/>
              </a:rPr>
              <a:t>Use victims to deliver message to others – 9 groups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marL="212400" indent="-212400">
              <a:lnSpc>
                <a:spcPct val="100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  <a:ea typeface="Arial"/>
              </a:rPr>
              <a:t>Use religious leaders – 7 groups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marL="212400" indent="-212400">
              <a:lnSpc>
                <a:spcPct val="100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  <a:ea typeface="Arial"/>
              </a:rPr>
              <a:t>Billboards &amp; posters – 6 groups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marL="212400" indent="-212400">
              <a:lnSpc>
                <a:spcPct val="100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  <a:ea typeface="Arial"/>
              </a:rPr>
              <a:t>TV Ads – 3 groups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marL="212400" indent="-212400">
              <a:lnSpc>
                <a:spcPct val="100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  <a:ea typeface="Arial"/>
              </a:rPr>
              <a:t>Newspaper Ads – 2 groups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marL="212400" indent="-212400">
              <a:lnSpc>
                <a:spcPct val="100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1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Summary 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2" name=""/>
          <p:cNvSpPr txBox="1"/>
          <p:nvPr/>
        </p:nvSpPr>
        <p:spPr>
          <a:xfrm>
            <a:off x="514080" y="1600200"/>
            <a:ext cx="925812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Each group has their own group specific determinants for ST use, which need to be addressed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eir communication methods are complex and need to be understood in developing a communication strategy to combat S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eir proposals on control methods need to be considered in developing a strategy to control ST use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9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1. Fishing community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30" name="Picture 5" descr=""/>
          <p:cNvPicPr/>
          <p:nvPr/>
        </p:nvPicPr>
        <p:blipFill>
          <a:blip r:embed="rId1"/>
          <a:stretch/>
        </p:blipFill>
        <p:spPr>
          <a:xfrm>
            <a:off x="2514600" y="1719360"/>
            <a:ext cx="4627440" cy="4287600"/>
          </a:xfrm>
          <a:prstGeom prst="rect">
            <a:avLst/>
          </a:prstGeom>
          <a:ln w="0">
            <a:noFill/>
          </a:ln>
        </p:spPr>
      </p:pic>
      <p:pic>
        <p:nvPicPr>
          <p:cNvPr id="131" name="" descr=""/>
          <p:cNvPicPr/>
          <p:nvPr/>
        </p:nvPicPr>
        <p:blipFill>
          <a:blip r:embed="rId2"/>
          <a:stretch/>
        </p:blipFill>
        <p:spPr>
          <a:xfrm>
            <a:off x="514080" y="1600200"/>
            <a:ext cx="9258120" cy="4525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Fishing community - determinants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33" name=""/>
          <p:cNvGraphicFramePr/>
          <p:nvPr/>
        </p:nvGraphicFramePr>
        <p:xfrm>
          <a:off x="577800" y="1117440"/>
          <a:ext cx="7386840" cy="2610000"/>
        </p:xfrm>
        <a:graphic>
          <a:graphicData uri="http://schemas.openxmlformats.org/drawingml/2006/table">
            <a:tbl>
              <a:tblPr/>
              <a:tblGrid>
                <a:gridCol w="7386840"/>
              </a:tblGrid>
              <a:tr h="2610000">
                <a:tc>
                  <a:txBody>
                    <a:bodyPr lIns="96480" rIns="96480" tIns="0" bIns="0" anchor="t">
                      <a:noAutofit/>
                    </a:bodyPr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etness, Cold weather, Dampness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leepiness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oneliness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way from home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just">
                        <a:lnSpc>
                          <a:spcPct val="107000"/>
                        </a:lnSpc>
                        <a:buClr>
                          <a:srgbClr val="000000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njoyment of reflex of Chewing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6480" marR="96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PlaceHolder 1"/>
          <p:cNvSpPr>
            <a:spLocks noGrp="1"/>
          </p:cNvSpPr>
          <p:nvPr>
            <p:ph type="title"/>
          </p:nvPr>
        </p:nvSpPr>
        <p:spPr>
          <a:xfrm>
            <a:off x="514080" y="274320"/>
            <a:ext cx="925812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Calibri"/>
              </a:rPr>
              <a:t>Fishing community – Communication methods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35" name=""/>
          <p:cNvGraphicFramePr/>
          <p:nvPr/>
        </p:nvGraphicFramePr>
        <p:xfrm>
          <a:off x="763560" y="1023840"/>
          <a:ext cx="6678720" cy="3000600"/>
        </p:xfrm>
        <a:graphic>
          <a:graphicData uri="http://schemas.openxmlformats.org/drawingml/2006/table">
            <a:tbl>
              <a:tblPr/>
              <a:tblGrid>
                <a:gridCol w="6678720"/>
              </a:tblGrid>
              <a:tr h="3000600">
                <a:tc>
                  <a:txBody>
                    <a:bodyPr lIns="57960" rIns="57960" tIns="0" bIns="0" anchor="t">
                      <a:noAutofit/>
                    </a:bodyPr>
                    <a:p>
                      <a:pPr marL="343080" indent="-343080">
                        <a:lnSpc>
                          <a:spcPct val="107000"/>
                        </a:lnSpc>
                        <a:buClr>
                          <a:srgbClr val="ffffff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32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Illiterate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>
                        <a:lnSpc>
                          <a:spcPct val="107000"/>
                        </a:lnSpc>
                        <a:buClr>
                          <a:srgbClr val="ffffff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32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Newspapers / radio of no use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>
                        <a:lnSpc>
                          <a:spcPct val="107000"/>
                        </a:lnSpc>
                        <a:buClr>
                          <a:srgbClr val="ffffff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32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Posters (Only photos and pictures)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>
                        <a:lnSpc>
                          <a:spcPct val="107000"/>
                        </a:lnSpc>
                        <a:buClr>
                          <a:srgbClr val="ffffff"/>
                        </a:buClr>
                        <a:buFont typeface="Symbol" charset="2"/>
                        <a:buChar char=""/>
                        <a:tabLst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32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TV - Hiru, Derana, Sirasa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>
                        <a:lnSpc>
                          <a:spcPct val="107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24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 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7960" marR="579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9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10-07T01:53:09Z</dcterms:created>
  <dc:creator>Nilantha</dc:creator>
  <dc:description/>
  <dc:language>en-US</dc:language>
  <cp:lastModifiedBy>AMARASINGHE ARACHCHIGE BINUKA SANJULA AMARASINGHE</cp:lastModifiedBy>
  <dcterms:modified xsi:type="dcterms:W3CDTF">2022-11-17T17:37:52Z</dcterms:modified>
  <cp:revision>63</cp:revision>
  <dc:subject/>
  <dc:title>Results</dc:title>
</cp:coreProperties>
</file>